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media/image5.png" ContentType="image/png"/>
  <Override PartName="/ppt/media/image10.png" ContentType="image/png"/>
  <Override PartName="/ppt/media/image6.png" ContentType="image/png"/>
  <Override PartName="/ppt/media/image11.png" ContentType="image/png"/>
  <Override PartName="/ppt/media/image7.png" ContentType="image/png"/>
  <Override PartName="/ppt/media/image12.png" ContentType="image/png"/>
  <Override PartName="/ppt/media/image8.png" ContentType="image/png"/>
  <Override PartName="/ppt/media/image9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7559675" cy="10691813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8C5F942-5ACB-48EB-916C-B270B1A0E56C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78000" y="428760"/>
            <a:ext cx="6805440" cy="1782720"/>
          </a:xfrm>
          <a:prstGeom prst="rect">
            <a:avLst/>
          </a:prstGeom>
          <a:noFill/>
          <a:ln w="0">
            <a:noFill/>
          </a:ln>
        </p:spPr>
        <p:txBody>
          <a:bodyPr lIns="104400" rIns="104400" tIns="52200" bIns="52200" anchor="ctr">
            <a:noAutofit/>
          </a:bodyPr>
          <a:p>
            <a:pPr indent="0" algn="ctr">
              <a:buNone/>
              <a:tabLst>
                <a:tab algn="l" pos="0"/>
                <a:tab algn="l" pos="1042920"/>
                <a:tab algn="l" pos="2085840"/>
                <a:tab algn="l" pos="3129120"/>
                <a:tab algn="l" pos="4172040"/>
                <a:tab algn="l" pos="5214960"/>
                <a:tab algn="l" pos="6257880"/>
                <a:tab algn="l" pos="7300800"/>
                <a:tab algn="l" pos="8344080"/>
                <a:tab algn="l" pos="9387000"/>
                <a:tab algn="l" pos="10429920"/>
              </a:tabLst>
            </a:pPr>
            <a:endParaRPr b="0" lang="en-US" sz="5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78000" y="2494080"/>
            <a:ext cx="6805440" cy="3367080"/>
          </a:xfrm>
          <a:prstGeom prst="rect">
            <a:avLst/>
          </a:prstGeom>
          <a:noFill/>
          <a:ln w="0">
            <a:noFill/>
          </a:ln>
        </p:spPr>
        <p:txBody>
          <a:bodyPr lIns="104400" rIns="104400" tIns="52200" bIns="52200" anchor="t">
            <a:normAutofit/>
          </a:bodyPr>
          <a:p>
            <a:pPr indent="0">
              <a:spcBef>
                <a:spcPts val="924"/>
              </a:spcBef>
              <a:buNone/>
              <a:tabLst>
                <a:tab algn="l" pos="1042920"/>
                <a:tab algn="l" pos="2085840"/>
                <a:tab algn="l" pos="3129120"/>
                <a:tab algn="l" pos="4172040"/>
                <a:tab algn="l" pos="5214960"/>
                <a:tab algn="l" pos="6257880"/>
                <a:tab algn="l" pos="7300800"/>
                <a:tab algn="l" pos="8344080"/>
                <a:tab algn="l" pos="9387000"/>
                <a:tab algn="l" pos="10429920"/>
              </a:tabLst>
            </a:pPr>
            <a:endParaRPr b="0" lang="en-US" sz="3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78000" y="6181560"/>
            <a:ext cx="6805440" cy="3367080"/>
          </a:xfrm>
          <a:prstGeom prst="rect">
            <a:avLst/>
          </a:prstGeom>
          <a:noFill/>
          <a:ln w="0">
            <a:noFill/>
          </a:ln>
        </p:spPr>
        <p:txBody>
          <a:bodyPr lIns="104400" rIns="104400" tIns="52200" bIns="52200" anchor="t">
            <a:normAutofit/>
          </a:bodyPr>
          <a:p>
            <a:pPr indent="0">
              <a:spcBef>
                <a:spcPts val="924"/>
              </a:spcBef>
              <a:buNone/>
              <a:tabLst>
                <a:tab algn="l" pos="1042920"/>
                <a:tab algn="l" pos="2085840"/>
                <a:tab algn="l" pos="3129120"/>
                <a:tab algn="l" pos="4172040"/>
                <a:tab algn="l" pos="5214960"/>
                <a:tab algn="l" pos="6257880"/>
                <a:tab algn="l" pos="7300800"/>
                <a:tab algn="l" pos="8344080"/>
                <a:tab algn="l" pos="9387000"/>
                <a:tab algn="l" pos="10429920"/>
              </a:tabLst>
            </a:pPr>
            <a:endParaRPr b="0" lang="en-US" sz="3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8C53E2C-5471-41C3-B41F-AB1E66EC67F4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78000" y="428760"/>
            <a:ext cx="6805440" cy="1782720"/>
          </a:xfrm>
          <a:prstGeom prst="rect">
            <a:avLst/>
          </a:prstGeom>
          <a:noFill/>
          <a:ln w="0">
            <a:noFill/>
          </a:ln>
        </p:spPr>
        <p:txBody>
          <a:bodyPr lIns="104400" rIns="104400" tIns="52200" bIns="52200" anchor="ctr">
            <a:noAutofit/>
          </a:bodyPr>
          <a:p>
            <a:pPr indent="0" algn="ctr">
              <a:buNone/>
              <a:tabLst>
                <a:tab algn="l" pos="0"/>
                <a:tab algn="l" pos="1042920"/>
                <a:tab algn="l" pos="2085840"/>
                <a:tab algn="l" pos="3129120"/>
                <a:tab algn="l" pos="4172040"/>
                <a:tab algn="l" pos="5214960"/>
                <a:tab algn="l" pos="6257880"/>
                <a:tab algn="l" pos="7300800"/>
                <a:tab algn="l" pos="8344080"/>
                <a:tab algn="l" pos="9387000"/>
                <a:tab algn="l" pos="10429920"/>
              </a:tabLst>
            </a:pPr>
            <a:endParaRPr b="0" lang="en-US" sz="5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78000" y="2494080"/>
            <a:ext cx="3321000" cy="3367080"/>
          </a:xfrm>
          <a:prstGeom prst="rect">
            <a:avLst/>
          </a:prstGeom>
          <a:noFill/>
          <a:ln w="0">
            <a:noFill/>
          </a:ln>
        </p:spPr>
        <p:txBody>
          <a:bodyPr lIns="104400" rIns="104400" tIns="52200" bIns="52200" anchor="t">
            <a:normAutofit/>
          </a:bodyPr>
          <a:p>
            <a:pPr indent="0">
              <a:spcBef>
                <a:spcPts val="924"/>
              </a:spcBef>
              <a:buNone/>
              <a:tabLst>
                <a:tab algn="l" pos="1042920"/>
                <a:tab algn="l" pos="2085840"/>
                <a:tab algn="l" pos="3129120"/>
                <a:tab algn="l" pos="4172040"/>
                <a:tab algn="l" pos="5214960"/>
                <a:tab algn="l" pos="6257880"/>
                <a:tab algn="l" pos="7300800"/>
                <a:tab algn="l" pos="8344080"/>
                <a:tab algn="l" pos="9387000"/>
                <a:tab algn="l" pos="10429920"/>
              </a:tabLst>
            </a:pPr>
            <a:endParaRPr b="0" lang="en-US" sz="3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865320" y="2494080"/>
            <a:ext cx="3321000" cy="3367080"/>
          </a:xfrm>
          <a:prstGeom prst="rect">
            <a:avLst/>
          </a:prstGeom>
          <a:noFill/>
          <a:ln w="0">
            <a:noFill/>
          </a:ln>
        </p:spPr>
        <p:txBody>
          <a:bodyPr lIns="104400" rIns="104400" tIns="52200" bIns="52200" anchor="t">
            <a:normAutofit/>
          </a:bodyPr>
          <a:p>
            <a:pPr indent="0">
              <a:spcBef>
                <a:spcPts val="924"/>
              </a:spcBef>
              <a:buNone/>
              <a:tabLst>
                <a:tab algn="l" pos="1042920"/>
                <a:tab algn="l" pos="2085840"/>
                <a:tab algn="l" pos="3129120"/>
                <a:tab algn="l" pos="4172040"/>
                <a:tab algn="l" pos="5214960"/>
                <a:tab algn="l" pos="6257880"/>
                <a:tab algn="l" pos="7300800"/>
                <a:tab algn="l" pos="8344080"/>
                <a:tab algn="l" pos="9387000"/>
                <a:tab algn="l" pos="10429920"/>
              </a:tabLst>
            </a:pPr>
            <a:endParaRPr b="0" lang="en-US" sz="3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78000" y="6181560"/>
            <a:ext cx="3321000" cy="3367080"/>
          </a:xfrm>
          <a:prstGeom prst="rect">
            <a:avLst/>
          </a:prstGeom>
          <a:noFill/>
          <a:ln w="0">
            <a:noFill/>
          </a:ln>
        </p:spPr>
        <p:txBody>
          <a:bodyPr lIns="104400" rIns="104400" tIns="52200" bIns="52200" anchor="t">
            <a:normAutofit/>
          </a:bodyPr>
          <a:p>
            <a:pPr indent="0">
              <a:spcBef>
                <a:spcPts val="924"/>
              </a:spcBef>
              <a:buNone/>
              <a:tabLst>
                <a:tab algn="l" pos="1042920"/>
                <a:tab algn="l" pos="2085840"/>
                <a:tab algn="l" pos="3129120"/>
                <a:tab algn="l" pos="4172040"/>
                <a:tab algn="l" pos="5214960"/>
                <a:tab algn="l" pos="6257880"/>
                <a:tab algn="l" pos="7300800"/>
                <a:tab algn="l" pos="8344080"/>
                <a:tab algn="l" pos="9387000"/>
                <a:tab algn="l" pos="10429920"/>
              </a:tabLst>
            </a:pPr>
            <a:endParaRPr b="0" lang="en-US" sz="3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865320" y="6181560"/>
            <a:ext cx="3321000" cy="3367080"/>
          </a:xfrm>
          <a:prstGeom prst="rect">
            <a:avLst/>
          </a:prstGeom>
          <a:noFill/>
          <a:ln w="0">
            <a:noFill/>
          </a:ln>
        </p:spPr>
        <p:txBody>
          <a:bodyPr lIns="104400" rIns="104400" tIns="52200" bIns="52200" anchor="t">
            <a:normAutofit/>
          </a:bodyPr>
          <a:p>
            <a:pPr indent="0">
              <a:spcBef>
                <a:spcPts val="924"/>
              </a:spcBef>
              <a:buNone/>
              <a:tabLst>
                <a:tab algn="l" pos="1042920"/>
                <a:tab algn="l" pos="2085840"/>
                <a:tab algn="l" pos="3129120"/>
                <a:tab algn="l" pos="4172040"/>
                <a:tab algn="l" pos="5214960"/>
                <a:tab algn="l" pos="6257880"/>
                <a:tab algn="l" pos="7300800"/>
                <a:tab algn="l" pos="8344080"/>
                <a:tab algn="l" pos="9387000"/>
                <a:tab algn="l" pos="10429920"/>
              </a:tabLst>
            </a:pPr>
            <a:endParaRPr b="0" lang="en-US" sz="3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E3ED0F9-605D-423F-B60B-CB38B65483BD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78000" y="428760"/>
            <a:ext cx="6805440" cy="1782720"/>
          </a:xfrm>
          <a:prstGeom prst="rect">
            <a:avLst/>
          </a:prstGeom>
          <a:noFill/>
          <a:ln w="0">
            <a:noFill/>
          </a:ln>
        </p:spPr>
        <p:txBody>
          <a:bodyPr lIns="104400" rIns="104400" tIns="52200" bIns="52200" anchor="ctr">
            <a:noAutofit/>
          </a:bodyPr>
          <a:p>
            <a:pPr indent="0" algn="ctr">
              <a:buNone/>
              <a:tabLst>
                <a:tab algn="l" pos="0"/>
                <a:tab algn="l" pos="1042920"/>
                <a:tab algn="l" pos="2085840"/>
                <a:tab algn="l" pos="3129120"/>
                <a:tab algn="l" pos="4172040"/>
                <a:tab algn="l" pos="5214960"/>
                <a:tab algn="l" pos="6257880"/>
                <a:tab algn="l" pos="7300800"/>
                <a:tab algn="l" pos="8344080"/>
                <a:tab algn="l" pos="9387000"/>
                <a:tab algn="l" pos="10429920"/>
              </a:tabLst>
            </a:pPr>
            <a:endParaRPr b="0" lang="en-US" sz="5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78000" y="2494080"/>
            <a:ext cx="2190960" cy="3367080"/>
          </a:xfrm>
          <a:prstGeom prst="rect">
            <a:avLst/>
          </a:prstGeom>
          <a:noFill/>
          <a:ln w="0">
            <a:noFill/>
          </a:ln>
        </p:spPr>
        <p:txBody>
          <a:bodyPr lIns="104400" rIns="104400" tIns="52200" bIns="52200" anchor="t">
            <a:normAutofit/>
          </a:bodyPr>
          <a:p>
            <a:pPr indent="0">
              <a:spcBef>
                <a:spcPts val="924"/>
              </a:spcBef>
              <a:buNone/>
              <a:tabLst>
                <a:tab algn="l" pos="1042920"/>
                <a:tab algn="l" pos="2085840"/>
                <a:tab algn="l" pos="3129120"/>
                <a:tab algn="l" pos="4172040"/>
                <a:tab algn="l" pos="5214960"/>
                <a:tab algn="l" pos="6257880"/>
                <a:tab algn="l" pos="7300800"/>
                <a:tab algn="l" pos="8344080"/>
                <a:tab algn="l" pos="9387000"/>
                <a:tab algn="l" pos="10429920"/>
              </a:tabLst>
            </a:pPr>
            <a:endParaRPr b="0" lang="en-US" sz="3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678760" y="2494080"/>
            <a:ext cx="2190960" cy="3367080"/>
          </a:xfrm>
          <a:prstGeom prst="rect">
            <a:avLst/>
          </a:prstGeom>
          <a:noFill/>
          <a:ln w="0">
            <a:noFill/>
          </a:ln>
        </p:spPr>
        <p:txBody>
          <a:bodyPr lIns="104400" rIns="104400" tIns="52200" bIns="52200" anchor="t">
            <a:normAutofit/>
          </a:bodyPr>
          <a:p>
            <a:pPr indent="0">
              <a:spcBef>
                <a:spcPts val="924"/>
              </a:spcBef>
              <a:buNone/>
              <a:tabLst>
                <a:tab algn="l" pos="1042920"/>
                <a:tab algn="l" pos="2085840"/>
                <a:tab algn="l" pos="3129120"/>
                <a:tab algn="l" pos="4172040"/>
                <a:tab algn="l" pos="5214960"/>
                <a:tab algn="l" pos="6257880"/>
                <a:tab algn="l" pos="7300800"/>
                <a:tab algn="l" pos="8344080"/>
                <a:tab algn="l" pos="9387000"/>
                <a:tab algn="l" pos="10429920"/>
              </a:tabLst>
            </a:pPr>
            <a:endParaRPr b="0" lang="en-US" sz="3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979880" y="2494080"/>
            <a:ext cx="2190960" cy="3367080"/>
          </a:xfrm>
          <a:prstGeom prst="rect">
            <a:avLst/>
          </a:prstGeom>
          <a:noFill/>
          <a:ln w="0">
            <a:noFill/>
          </a:ln>
        </p:spPr>
        <p:txBody>
          <a:bodyPr lIns="104400" rIns="104400" tIns="52200" bIns="52200" anchor="t">
            <a:normAutofit/>
          </a:bodyPr>
          <a:p>
            <a:pPr indent="0">
              <a:spcBef>
                <a:spcPts val="924"/>
              </a:spcBef>
              <a:buNone/>
              <a:tabLst>
                <a:tab algn="l" pos="1042920"/>
                <a:tab algn="l" pos="2085840"/>
                <a:tab algn="l" pos="3129120"/>
                <a:tab algn="l" pos="4172040"/>
                <a:tab algn="l" pos="5214960"/>
                <a:tab algn="l" pos="6257880"/>
                <a:tab algn="l" pos="7300800"/>
                <a:tab algn="l" pos="8344080"/>
                <a:tab algn="l" pos="9387000"/>
                <a:tab algn="l" pos="10429920"/>
              </a:tabLst>
            </a:pPr>
            <a:endParaRPr b="0" lang="en-US" sz="3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78000" y="6181560"/>
            <a:ext cx="2190960" cy="3367080"/>
          </a:xfrm>
          <a:prstGeom prst="rect">
            <a:avLst/>
          </a:prstGeom>
          <a:noFill/>
          <a:ln w="0">
            <a:noFill/>
          </a:ln>
        </p:spPr>
        <p:txBody>
          <a:bodyPr lIns="104400" rIns="104400" tIns="52200" bIns="52200" anchor="t">
            <a:normAutofit/>
          </a:bodyPr>
          <a:p>
            <a:pPr indent="0">
              <a:spcBef>
                <a:spcPts val="924"/>
              </a:spcBef>
              <a:buNone/>
              <a:tabLst>
                <a:tab algn="l" pos="1042920"/>
                <a:tab algn="l" pos="2085840"/>
                <a:tab algn="l" pos="3129120"/>
                <a:tab algn="l" pos="4172040"/>
                <a:tab algn="l" pos="5214960"/>
                <a:tab algn="l" pos="6257880"/>
                <a:tab algn="l" pos="7300800"/>
                <a:tab algn="l" pos="8344080"/>
                <a:tab algn="l" pos="9387000"/>
                <a:tab algn="l" pos="10429920"/>
              </a:tabLst>
            </a:pPr>
            <a:endParaRPr b="0" lang="en-US" sz="3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678760" y="6181560"/>
            <a:ext cx="2190960" cy="3367080"/>
          </a:xfrm>
          <a:prstGeom prst="rect">
            <a:avLst/>
          </a:prstGeom>
          <a:noFill/>
          <a:ln w="0">
            <a:noFill/>
          </a:ln>
        </p:spPr>
        <p:txBody>
          <a:bodyPr lIns="104400" rIns="104400" tIns="52200" bIns="52200" anchor="t">
            <a:normAutofit/>
          </a:bodyPr>
          <a:p>
            <a:pPr indent="0">
              <a:spcBef>
                <a:spcPts val="924"/>
              </a:spcBef>
              <a:buNone/>
              <a:tabLst>
                <a:tab algn="l" pos="1042920"/>
                <a:tab algn="l" pos="2085840"/>
                <a:tab algn="l" pos="3129120"/>
                <a:tab algn="l" pos="4172040"/>
                <a:tab algn="l" pos="5214960"/>
                <a:tab algn="l" pos="6257880"/>
                <a:tab algn="l" pos="7300800"/>
                <a:tab algn="l" pos="8344080"/>
                <a:tab algn="l" pos="9387000"/>
                <a:tab algn="l" pos="10429920"/>
              </a:tabLst>
            </a:pPr>
            <a:endParaRPr b="0" lang="en-US" sz="3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979880" y="6181560"/>
            <a:ext cx="2190960" cy="3367080"/>
          </a:xfrm>
          <a:prstGeom prst="rect">
            <a:avLst/>
          </a:prstGeom>
          <a:noFill/>
          <a:ln w="0">
            <a:noFill/>
          </a:ln>
        </p:spPr>
        <p:txBody>
          <a:bodyPr lIns="104400" rIns="104400" tIns="52200" bIns="52200" anchor="t">
            <a:normAutofit/>
          </a:bodyPr>
          <a:p>
            <a:pPr indent="0">
              <a:spcBef>
                <a:spcPts val="924"/>
              </a:spcBef>
              <a:buNone/>
              <a:tabLst>
                <a:tab algn="l" pos="1042920"/>
                <a:tab algn="l" pos="2085840"/>
                <a:tab algn="l" pos="3129120"/>
                <a:tab algn="l" pos="4172040"/>
                <a:tab algn="l" pos="5214960"/>
                <a:tab algn="l" pos="6257880"/>
                <a:tab algn="l" pos="7300800"/>
                <a:tab algn="l" pos="8344080"/>
                <a:tab algn="l" pos="9387000"/>
                <a:tab algn="l" pos="10429920"/>
              </a:tabLst>
            </a:pPr>
            <a:endParaRPr b="0" lang="en-US" sz="3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F0B95B1-13F7-45D1-A047-66F7CD308E59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78000" y="428760"/>
            <a:ext cx="6805440" cy="1782720"/>
          </a:xfrm>
          <a:prstGeom prst="rect">
            <a:avLst/>
          </a:prstGeom>
          <a:noFill/>
          <a:ln w="0">
            <a:noFill/>
          </a:ln>
        </p:spPr>
        <p:txBody>
          <a:bodyPr lIns="104400" rIns="104400" tIns="52200" bIns="52200" anchor="ctr">
            <a:noAutofit/>
          </a:bodyPr>
          <a:p>
            <a:pPr indent="0" algn="ctr">
              <a:buNone/>
              <a:tabLst>
                <a:tab algn="l" pos="0"/>
                <a:tab algn="l" pos="1042920"/>
                <a:tab algn="l" pos="2085840"/>
                <a:tab algn="l" pos="3129120"/>
                <a:tab algn="l" pos="4172040"/>
                <a:tab algn="l" pos="5214960"/>
                <a:tab algn="l" pos="6257880"/>
                <a:tab algn="l" pos="7300800"/>
                <a:tab algn="l" pos="8344080"/>
                <a:tab algn="l" pos="9387000"/>
                <a:tab algn="l" pos="10429920"/>
              </a:tabLst>
            </a:pPr>
            <a:endParaRPr b="0" lang="en-US" sz="5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78000" y="2494080"/>
            <a:ext cx="6805440" cy="70596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924"/>
              </a:spcBef>
              <a:buNone/>
              <a:tabLst>
                <a:tab algn="l" pos="0"/>
                <a:tab algn="l" pos="1042920"/>
                <a:tab algn="l" pos="2085840"/>
                <a:tab algn="l" pos="3129120"/>
                <a:tab algn="l" pos="4172040"/>
                <a:tab algn="l" pos="5214960"/>
                <a:tab algn="l" pos="6257880"/>
                <a:tab algn="l" pos="7300800"/>
                <a:tab algn="l" pos="8344080"/>
                <a:tab algn="l" pos="9387000"/>
                <a:tab algn="l" pos="10429920"/>
              </a:tabLst>
            </a:pPr>
            <a:endParaRPr b="0" lang="en-US" sz="3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D5A4E1A-7434-4EF6-AEEB-7428DA38539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78000" y="428760"/>
            <a:ext cx="6805440" cy="1782720"/>
          </a:xfrm>
          <a:prstGeom prst="rect">
            <a:avLst/>
          </a:prstGeom>
          <a:noFill/>
          <a:ln w="0">
            <a:noFill/>
          </a:ln>
        </p:spPr>
        <p:txBody>
          <a:bodyPr lIns="104400" rIns="104400" tIns="52200" bIns="52200" anchor="ctr">
            <a:noAutofit/>
          </a:bodyPr>
          <a:p>
            <a:pPr indent="0" algn="ctr">
              <a:buNone/>
              <a:tabLst>
                <a:tab algn="l" pos="0"/>
                <a:tab algn="l" pos="1042920"/>
                <a:tab algn="l" pos="2085840"/>
                <a:tab algn="l" pos="3129120"/>
                <a:tab algn="l" pos="4172040"/>
                <a:tab algn="l" pos="5214960"/>
                <a:tab algn="l" pos="6257880"/>
                <a:tab algn="l" pos="7300800"/>
                <a:tab algn="l" pos="8344080"/>
                <a:tab algn="l" pos="9387000"/>
                <a:tab algn="l" pos="10429920"/>
              </a:tabLst>
            </a:pPr>
            <a:endParaRPr b="0" lang="en-US" sz="5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78000" y="2494080"/>
            <a:ext cx="6805440" cy="7059600"/>
          </a:xfrm>
          <a:prstGeom prst="rect">
            <a:avLst/>
          </a:prstGeom>
          <a:noFill/>
          <a:ln w="0">
            <a:noFill/>
          </a:ln>
        </p:spPr>
        <p:txBody>
          <a:bodyPr lIns="104400" rIns="104400" tIns="52200" bIns="52200" anchor="t">
            <a:normAutofit/>
          </a:bodyPr>
          <a:p>
            <a:pPr indent="0">
              <a:spcBef>
                <a:spcPts val="924"/>
              </a:spcBef>
              <a:buNone/>
              <a:tabLst>
                <a:tab algn="l" pos="1042920"/>
                <a:tab algn="l" pos="2085840"/>
                <a:tab algn="l" pos="3129120"/>
                <a:tab algn="l" pos="4172040"/>
                <a:tab algn="l" pos="5214960"/>
                <a:tab algn="l" pos="6257880"/>
                <a:tab algn="l" pos="7300800"/>
                <a:tab algn="l" pos="8344080"/>
                <a:tab algn="l" pos="9387000"/>
                <a:tab algn="l" pos="10429920"/>
              </a:tabLst>
            </a:pPr>
            <a:endParaRPr b="0" lang="en-US" sz="3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40EEE08-889C-4C61-8039-3EEDA6C8D81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78000" y="428760"/>
            <a:ext cx="6805440" cy="1782720"/>
          </a:xfrm>
          <a:prstGeom prst="rect">
            <a:avLst/>
          </a:prstGeom>
          <a:noFill/>
          <a:ln w="0">
            <a:noFill/>
          </a:ln>
        </p:spPr>
        <p:txBody>
          <a:bodyPr lIns="104400" rIns="104400" tIns="52200" bIns="52200" anchor="ctr">
            <a:noAutofit/>
          </a:bodyPr>
          <a:p>
            <a:pPr indent="0" algn="ctr">
              <a:buNone/>
              <a:tabLst>
                <a:tab algn="l" pos="0"/>
                <a:tab algn="l" pos="1042920"/>
                <a:tab algn="l" pos="2085840"/>
                <a:tab algn="l" pos="3129120"/>
                <a:tab algn="l" pos="4172040"/>
                <a:tab algn="l" pos="5214960"/>
                <a:tab algn="l" pos="6257880"/>
                <a:tab algn="l" pos="7300800"/>
                <a:tab algn="l" pos="8344080"/>
                <a:tab algn="l" pos="9387000"/>
                <a:tab algn="l" pos="10429920"/>
              </a:tabLst>
            </a:pPr>
            <a:endParaRPr b="0" lang="en-US" sz="5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78000" y="2494080"/>
            <a:ext cx="3321000" cy="7059600"/>
          </a:xfrm>
          <a:prstGeom prst="rect">
            <a:avLst/>
          </a:prstGeom>
          <a:noFill/>
          <a:ln w="0">
            <a:noFill/>
          </a:ln>
        </p:spPr>
        <p:txBody>
          <a:bodyPr lIns="104400" rIns="104400" tIns="52200" bIns="52200" anchor="t">
            <a:normAutofit/>
          </a:bodyPr>
          <a:p>
            <a:pPr indent="0">
              <a:spcBef>
                <a:spcPts val="924"/>
              </a:spcBef>
              <a:buNone/>
              <a:tabLst>
                <a:tab algn="l" pos="1042920"/>
                <a:tab algn="l" pos="2085840"/>
                <a:tab algn="l" pos="3129120"/>
                <a:tab algn="l" pos="4172040"/>
                <a:tab algn="l" pos="5214960"/>
                <a:tab algn="l" pos="6257880"/>
                <a:tab algn="l" pos="7300800"/>
                <a:tab algn="l" pos="8344080"/>
                <a:tab algn="l" pos="9387000"/>
                <a:tab algn="l" pos="10429920"/>
              </a:tabLst>
            </a:pPr>
            <a:endParaRPr b="0" lang="en-US" sz="3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865320" y="2494080"/>
            <a:ext cx="3321000" cy="7059600"/>
          </a:xfrm>
          <a:prstGeom prst="rect">
            <a:avLst/>
          </a:prstGeom>
          <a:noFill/>
          <a:ln w="0">
            <a:noFill/>
          </a:ln>
        </p:spPr>
        <p:txBody>
          <a:bodyPr lIns="104400" rIns="104400" tIns="52200" bIns="52200" anchor="t">
            <a:normAutofit/>
          </a:bodyPr>
          <a:p>
            <a:pPr indent="0">
              <a:spcBef>
                <a:spcPts val="924"/>
              </a:spcBef>
              <a:buNone/>
              <a:tabLst>
                <a:tab algn="l" pos="1042920"/>
                <a:tab algn="l" pos="2085840"/>
                <a:tab algn="l" pos="3129120"/>
                <a:tab algn="l" pos="4172040"/>
                <a:tab algn="l" pos="5214960"/>
                <a:tab algn="l" pos="6257880"/>
                <a:tab algn="l" pos="7300800"/>
                <a:tab algn="l" pos="8344080"/>
                <a:tab algn="l" pos="9387000"/>
                <a:tab algn="l" pos="10429920"/>
              </a:tabLst>
            </a:pPr>
            <a:endParaRPr b="0" lang="en-US" sz="3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91883BD-988E-41C5-8ACA-FFF74D06F63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78000" y="428760"/>
            <a:ext cx="6805440" cy="1782720"/>
          </a:xfrm>
          <a:prstGeom prst="rect">
            <a:avLst/>
          </a:prstGeom>
          <a:noFill/>
          <a:ln w="0">
            <a:noFill/>
          </a:ln>
        </p:spPr>
        <p:txBody>
          <a:bodyPr lIns="104400" rIns="104400" tIns="52200" bIns="52200" anchor="ctr">
            <a:noAutofit/>
          </a:bodyPr>
          <a:p>
            <a:pPr indent="0" algn="ctr">
              <a:buNone/>
              <a:tabLst>
                <a:tab algn="l" pos="0"/>
                <a:tab algn="l" pos="1042920"/>
                <a:tab algn="l" pos="2085840"/>
                <a:tab algn="l" pos="3129120"/>
                <a:tab algn="l" pos="4172040"/>
                <a:tab algn="l" pos="5214960"/>
                <a:tab algn="l" pos="6257880"/>
                <a:tab algn="l" pos="7300800"/>
                <a:tab algn="l" pos="8344080"/>
                <a:tab algn="l" pos="9387000"/>
                <a:tab algn="l" pos="10429920"/>
              </a:tabLst>
            </a:pPr>
            <a:endParaRPr b="0" lang="en-US" sz="5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1025B4F-FB07-49BF-B04A-B13EE3D6EC2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78000" y="428760"/>
            <a:ext cx="6805440" cy="82648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924"/>
              </a:spcBef>
              <a:tabLst>
                <a:tab algn="l" pos="0"/>
                <a:tab algn="l" pos="1042920"/>
                <a:tab algn="l" pos="2085840"/>
                <a:tab algn="l" pos="3129120"/>
                <a:tab algn="l" pos="4172040"/>
                <a:tab algn="l" pos="5214960"/>
                <a:tab algn="l" pos="6257880"/>
                <a:tab algn="l" pos="7300800"/>
                <a:tab algn="l" pos="8344080"/>
                <a:tab algn="l" pos="9387000"/>
                <a:tab algn="l" pos="10429920"/>
              </a:tabLst>
            </a:pPr>
            <a:endParaRPr b="0" lang="en-US" sz="3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8BE468C-7EF8-403E-890C-F2ADAAE07EF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78000" y="428760"/>
            <a:ext cx="6805440" cy="1782720"/>
          </a:xfrm>
          <a:prstGeom prst="rect">
            <a:avLst/>
          </a:prstGeom>
          <a:noFill/>
          <a:ln w="0">
            <a:noFill/>
          </a:ln>
        </p:spPr>
        <p:txBody>
          <a:bodyPr lIns="104400" rIns="104400" tIns="52200" bIns="52200" anchor="ctr">
            <a:noAutofit/>
          </a:bodyPr>
          <a:p>
            <a:pPr indent="0" algn="ctr">
              <a:buNone/>
              <a:tabLst>
                <a:tab algn="l" pos="0"/>
                <a:tab algn="l" pos="1042920"/>
                <a:tab algn="l" pos="2085840"/>
                <a:tab algn="l" pos="3129120"/>
                <a:tab algn="l" pos="4172040"/>
                <a:tab algn="l" pos="5214960"/>
                <a:tab algn="l" pos="6257880"/>
                <a:tab algn="l" pos="7300800"/>
                <a:tab algn="l" pos="8344080"/>
                <a:tab algn="l" pos="9387000"/>
                <a:tab algn="l" pos="10429920"/>
              </a:tabLst>
            </a:pPr>
            <a:endParaRPr b="0" lang="en-US" sz="5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78000" y="2494080"/>
            <a:ext cx="3321000" cy="3367080"/>
          </a:xfrm>
          <a:prstGeom prst="rect">
            <a:avLst/>
          </a:prstGeom>
          <a:noFill/>
          <a:ln w="0">
            <a:noFill/>
          </a:ln>
        </p:spPr>
        <p:txBody>
          <a:bodyPr lIns="104400" rIns="104400" tIns="52200" bIns="52200" anchor="t">
            <a:normAutofit/>
          </a:bodyPr>
          <a:p>
            <a:pPr indent="0">
              <a:spcBef>
                <a:spcPts val="924"/>
              </a:spcBef>
              <a:buNone/>
              <a:tabLst>
                <a:tab algn="l" pos="1042920"/>
                <a:tab algn="l" pos="2085840"/>
                <a:tab algn="l" pos="3129120"/>
                <a:tab algn="l" pos="4172040"/>
                <a:tab algn="l" pos="5214960"/>
                <a:tab algn="l" pos="6257880"/>
                <a:tab algn="l" pos="7300800"/>
                <a:tab algn="l" pos="8344080"/>
                <a:tab algn="l" pos="9387000"/>
                <a:tab algn="l" pos="10429920"/>
              </a:tabLst>
            </a:pPr>
            <a:endParaRPr b="0" lang="en-US" sz="3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865320" y="2494080"/>
            <a:ext cx="3321000" cy="7059600"/>
          </a:xfrm>
          <a:prstGeom prst="rect">
            <a:avLst/>
          </a:prstGeom>
          <a:noFill/>
          <a:ln w="0">
            <a:noFill/>
          </a:ln>
        </p:spPr>
        <p:txBody>
          <a:bodyPr lIns="104400" rIns="104400" tIns="52200" bIns="52200" anchor="t">
            <a:normAutofit/>
          </a:bodyPr>
          <a:p>
            <a:pPr indent="0">
              <a:spcBef>
                <a:spcPts val="924"/>
              </a:spcBef>
              <a:buNone/>
              <a:tabLst>
                <a:tab algn="l" pos="1042920"/>
                <a:tab algn="l" pos="2085840"/>
                <a:tab algn="l" pos="3129120"/>
                <a:tab algn="l" pos="4172040"/>
                <a:tab algn="l" pos="5214960"/>
                <a:tab algn="l" pos="6257880"/>
                <a:tab algn="l" pos="7300800"/>
                <a:tab algn="l" pos="8344080"/>
                <a:tab algn="l" pos="9387000"/>
                <a:tab algn="l" pos="10429920"/>
              </a:tabLst>
            </a:pPr>
            <a:endParaRPr b="0" lang="en-US" sz="3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78000" y="6181560"/>
            <a:ext cx="3321000" cy="3367080"/>
          </a:xfrm>
          <a:prstGeom prst="rect">
            <a:avLst/>
          </a:prstGeom>
          <a:noFill/>
          <a:ln w="0">
            <a:noFill/>
          </a:ln>
        </p:spPr>
        <p:txBody>
          <a:bodyPr lIns="104400" rIns="104400" tIns="52200" bIns="52200" anchor="t">
            <a:normAutofit/>
          </a:bodyPr>
          <a:p>
            <a:pPr indent="0">
              <a:spcBef>
                <a:spcPts val="924"/>
              </a:spcBef>
              <a:buNone/>
              <a:tabLst>
                <a:tab algn="l" pos="1042920"/>
                <a:tab algn="l" pos="2085840"/>
                <a:tab algn="l" pos="3129120"/>
                <a:tab algn="l" pos="4172040"/>
                <a:tab algn="l" pos="5214960"/>
                <a:tab algn="l" pos="6257880"/>
                <a:tab algn="l" pos="7300800"/>
                <a:tab algn="l" pos="8344080"/>
                <a:tab algn="l" pos="9387000"/>
                <a:tab algn="l" pos="10429920"/>
              </a:tabLst>
            </a:pPr>
            <a:endParaRPr b="0" lang="en-US" sz="3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D7A86C0-6F42-40B3-BFAF-6EB7FC70EA0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78000" y="428760"/>
            <a:ext cx="6805440" cy="1782720"/>
          </a:xfrm>
          <a:prstGeom prst="rect">
            <a:avLst/>
          </a:prstGeom>
          <a:noFill/>
          <a:ln w="0">
            <a:noFill/>
          </a:ln>
        </p:spPr>
        <p:txBody>
          <a:bodyPr lIns="104400" rIns="104400" tIns="52200" bIns="52200" anchor="ctr">
            <a:noAutofit/>
          </a:bodyPr>
          <a:p>
            <a:pPr indent="0" algn="ctr">
              <a:buNone/>
              <a:tabLst>
                <a:tab algn="l" pos="0"/>
                <a:tab algn="l" pos="1042920"/>
                <a:tab algn="l" pos="2085840"/>
                <a:tab algn="l" pos="3129120"/>
                <a:tab algn="l" pos="4172040"/>
                <a:tab algn="l" pos="5214960"/>
                <a:tab algn="l" pos="6257880"/>
                <a:tab algn="l" pos="7300800"/>
                <a:tab algn="l" pos="8344080"/>
                <a:tab algn="l" pos="9387000"/>
                <a:tab algn="l" pos="10429920"/>
              </a:tabLst>
            </a:pPr>
            <a:endParaRPr b="0" lang="en-US" sz="5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78000" y="2494080"/>
            <a:ext cx="3321000" cy="7059600"/>
          </a:xfrm>
          <a:prstGeom prst="rect">
            <a:avLst/>
          </a:prstGeom>
          <a:noFill/>
          <a:ln w="0">
            <a:noFill/>
          </a:ln>
        </p:spPr>
        <p:txBody>
          <a:bodyPr lIns="104400" rIns="104400" tIns="52200" bIns="52200" anchor="t">
            <a:normAutofit/>
          </a:bodyPr>
          <a:p>
            <a:pPr indent="0">
              <a:spcBef>
                <a:spcPts val="924"/>
              </a:spcBef>
              <a:buNone/>
              <a:tabLst>
                <a:tab algn="l" pos="1042920"/>
                <a:tab algn="l" pos="2085840"/>
                <a:tab algn="l" pos="3129120"/>
                <a:tab algn="l" pos="4172040"/>
                <a:tab algn="l" pos="5214960"/>
                <a:tab algn="l" pos="6257880"/>
                <a:tab algn="l" pos="7300800"/>
                <a:tab algn="l" pos="8344080"/>
                <a:tab algn="l" pos="9387000"/>
                <a:tab algn="l" pos="10429920"/>
              </a:tabLst>
            </a:pPr>
            <a:endParaRPr b="0" lang="en-US" sz="3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865320" y="2494080"/>
            <a:ext cx="3321000" cy="3367080"/>
          </a:xfrm>
          <a:prstGeom prst="rect">
            <a:avLst/>
          </a:prstGeom>
          <a:noFill/>
          <a:ln w="0">
            <a:noFill/>
          </a:ln>
        </p:spPr>
        <p:txBody>
          <a:bodyPr lIns="104400" rIns="104400" tIns="52200" bIns="52200" anchor="t">
            <a:normAutofit/>
          </a:bodyPr>
          <a:p>
            <a:pPr indent="0">
              <a:spcBef>
                <a:spcPts val="924"/>
              </a:spcBef>
              <a:buNone/>
              <a:tabLst>
                <a:tab algn="l" pos="1042920"/>
                <a:tab algn="l" pos="2085840"/>
                <a:tab algn="l" pos="3129120"/>
                <a:tab algn="l" pos="4172040"/>
                <a:tab algn="l" pos="5214960"/>
                <a:tab algn="l" pos="6257880"/>
                <a:tab algn="l" pos="7300800"/>
                <a:tab algn="l" pos="8344080"/>
                <a:tab algn="l" pos="9387000"/>
                <a:tab algn="l" pos="10429920"/>
              </a:tabLst>
            </a:pPr>
            <a:endParaRPr b="0" lang="en-US" sz="3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865320" y="6181560"/>
            <a:ext cx="3321000" cy="3367080"/>
          </a:xfrm>
          <a:prstGeom prst="rect">
            <a:avLst/>
          </a:prstGeom>
          <a:noFill/>
          <a:ln w="0">
            <a:noFill/>
          </a:ln>
        </p:spPr>
        <p:txBody>
          <a:bodyPr lIns="104400" rIns="104400" tIns="52200" bIns="52200" anchor="t">
            <a:normAutofit/>
          </a:bodyPr>
          <a:p>
            <a:pPr indent="0">
              <a:spcBef>
                <a:spcPts val="924"/>
              </a:spcBef>
              <a:buNone/>
              <a:tabLst>
                <a:tab algn="l" pos="1042920"/>
                <a:tab algn="l" pos="2085840"/>
                <a:tab algn="l" pos="3129120"/>
                <a:tab algn="l" pos="4172040"/>
                <a:tab algn="l" pos="5214960"/>
                <a:tab algn="l" pos="6257880"/>
                <a:tab algn="l" pos="7300800"/>
                <a:tab algn="l" pos="8344080"/>
                <a:tab algn="l" pos="9387000"/>
                <a:tab algn="l" pos="10429920"/>
              </a:tabLst>
            </a:pPr>
            <a:endParaRPr b="0" lang="en-US" sz="3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A4CDF67-8A8C-41FC-931A-4B66A791F51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78000" y="428760"/>
            <a:ext cx="6805440" cy="1782720"/>
          </a:xfrm>
          <a:prstGeom prst="rect">
            <a:avLst/>
          </a:prstGeom>
          <a:noFill/>
          <a:ln w="0">
            <a:noFill/>
          </a:ln>
        </p:spPr>
        <p:txBody>
          <a:bodyPr lIns="104400" rIns="104400" tIns="52200" bIns="52200" anchor="ctr">
            <a:noAutofit/>
          </a:bodyPr>
          <a:p>
            <a:pPr indent="0" algn="ctr">
              <a:buNone/>
              <a:tabLst>
                <a:tab algn="l" pos="0"/>
                <a:tab algn="l" pos="1042920"/>
                <a:tab algn="l" pos="2085840"/>
                <a:tab algn="l" pos="3129120"/>
                <a:tab algn="l" pos="4172040"/>
                <a:tab algn="l" pos="5214960"/>
                <a:tab algn="l" pos="6257880"/>
                <a:tab algn="l" pos="7300800"/>
                <a:tab algn="l" pos="8344080"/>
                <a:tab algn="l" pos="9387000"/>
                <a:tab algn="l" pos="10429920"/>
              </a:tabLst>
            </a:pPr>
            <a:endParaRPr b="0" lang="en-US" sz="5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78000" y="2494080"/>
            <a:ext cx="3321000" cy="3367080"/>
          </a:xfrm>
          <a:prstGeom prst="rect">
            <a:avLst/>
          </a:prstGeom>
          <a:noFill/>
          <a:ln w="0">
            <a:noFill/>
          </a:ln>
        </p:spPr>
        <p:txBody>
          <a:bodyPr lIns="104400" rIns="104400" tIns="52200" bIns="52200" anchor="t">
            <a:normAutofit/>
          </a:bodyPr>
          <a:p>
            <a:pPr indent="0">
              <a:spcBef>
                <a:spcPts val="924"/>
              </a:spcBef>
              <a:buNone/>
              <a:tabLst>
                <a:tab algn="l" pos="1042920"/>
                <a:tab algn="l" pos="2085840"/>
                <a:tab algn="l" pos="3129120"/>
                <a:tab algn="l" pos="4172040"/>
                <a:tab algn="l" pos="5214960"/>
                <a:tab algn="l" pos="6257880"/>
                <a:tab algn="l" pos="7300800"/>
                <a:tab algn="l" pos="8344080"/>
                <a:tab algn="l" pos="9387000"/>
                <a:tab algn="l" pos="10429920"/>
              </a:tabLst>
            </a:pPr>
            <a:endParaRPr b="0" lang="en-US" sz="3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865320" y="2494080"/>
            <a:ext cx="3321000" cy="3367080"/>
          </a:xfrm>
          <a:prstGeom prst="rect">
            <a:avLst/>
          </a:prstGeom>
          <a:noFill/>
          <a:ln w="0">
            <a:noFill/>
          </a:ln>
        </p:spPr>
        <p:txBody>
          <a:bodyPr lIns="104400" rIns="104400" tIns="52200" bIns="52200" anchor="t">
            <a:normAutofit/>
          </a:bodyPr>
          <a:p>
            <a:pPr indent="0">
              <a:spcBef>
                <a:spcPts val="924"/>
              </a:spcBef>
              <a:buNone/>
              <a:tabLst>
                <a:tab algn="l" pos="1042920"/>
                <a:tab algn="l" pos="2085840"/>
                <a:tab algn="l" pos="3129120"/>
                <a:tab algn="l" pos="4172040"/>
                <a:tab algn="l" pos="5214960"/>
                <a:tab algn="l" pos="6257880"/>
                <a:tab algn="l" pos="7300800"/>
                <a:tab algn="l" pos="8344080"/>
                <a:tab algn="l" pos="9387000"/>
                <a:tab algn="l" pos="10429920"/>
              </a:tabLst>
            </a:pPr>
            <a:endParaRPr b="0" lang="en-US" sz="3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78000" y="6181560"/>
            <a:ext cx="6805440" cy="3367080"/>
          </a:xfrm>
          <a:prstGeom prst="rect">
            <a:avLst/>
          </a:prstGeom>
          <a:noFill/>
          <a:ln w="0">
            <a:noFill/>
          </a:ln>
        </p:spPr>
        <p:txBody>
          <a:bodyPr lIns="104400" rIns="104400" tIns="52200" bIns="52200" anchor="t">
            <a:normAutofit/>
          </a:bodyPr>
          <a:p>
            <a:pPr indent="0">
              <a:spcBef>
                <a:spcPts val="924"/>
              </a:spcBef>
              <a:buNone/>
              <a:tabLst>
                <a:tab algn="l" pos="1042920"/>
                <a:tab algn="l" pos="2085840"/>
                <a:tab algn="l" pos="3129120"/>
                <a:tab algn="l" pos="4172040"/>
                <a:tab algn="l" pos="5214960"/>
                <a:tab algn="l" pos="6257880"/>
                <a:tab algn="l" pos="7300800"/>
                <a:tab algn="l" pos="8344080"/>
                <a:tab algn="l" pos="9387000"/>
                <a:tab algn="l" pos="10429920"/>
              </a:tabLst>
            </a:pPr>
            <a:endParaRPr b="0" lang="en-US" sz="3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4D4BB98-E04A-415C-AD57-3E694F157C8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78000" y="428760"/>
            <a:ext cx="6805440" cy="1782720"/>
          </a:xfrm>
          <a:prstGeom prst="rect">
            <a:avLst/>
          </a:prstGeom>
          <a:noFill/>
          <a:ln w="0">
            <a:noFill/>
          </a:ln>
        </p:spPr>
        <p:txBody>
          <a:bodyPr lIns="104400" rIns="104400" tIns="52200" bIns="52200" anchor="ctr">
            <a:noAutofit/>
          </a:bodyPr>
          <a:p>
            <a:pPr indent="0" algn="ctr">
              <a:buNone/>
              <a:tabLst>
                <a:tab algn="l" pos="0"/>
                <a:tab algn="l" pos="1042920"/>
                <a:tab algn="l" pos="2085840"/>
                <a:tab algn="l" pos="3129120"/>
                <a:tab algn="l" pos="4172040"/>
                <a:tab algn="l" pos="5214960"/>
                <a:tab algn="l" pos="6257880"/>
                <a:tab algn="l" pos="7300800"/>
                <a:tab algn="l" pos="8344080"/>
                <a:tab algn="l" pos="9387000"/>
                <a:tab algn="l" pos="10429920"/>
              </a:tabLst>
            </a:pPr>
            <a:r>
              <a:rPr b="0" lang="en-US" sz="50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5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78000" y="2494080"/>
            <a:ext cx="6805440" cy="7059600"/>
          </a:xfrm>
          <a:prstGeom prst="rect">
            <a:avLst/>
          </a:prstGeom>
          <a:noFill/>
          <a:ln w="0">
            <a:noFill/>
          </a:ln>
        </p:spPr>
        <p:txBody>
          <a:bodyPr lIns="104400" rIns="104400" tIns="52200" bIns="52200" anchor="t">
            <a:normAutofit/>
          </a:bodyPr>
          <a:p>
            <a:pPr marL="390600" indent="-390600">
              <a:spcBef>
                <a:spcPts val="924"/>
              </a:spcBef>
              <a:buClr>
                <a:srgbClr val="000000"/>
              </a:buClr>
              <a:buFont typeface="Arial"/>
              <a:buChar char="•"/>
              <a:tabLst>
                <a:tab algn="l" pos="1042920"/>
                <a:tab algn="l" pos="2085840"/>
                <a:tab algn="l" pos="3129120"/>
                <a:tab algn="l" pos="4172040"/>
                <a:tab algn="l" pos="5214960"/>
                <a:tab algn="l" pos="6257880"/>
                <a:tab algn="l" pos="7300800"/>
                <a:tab algn="l" pos="8344080"/>
                <a:tab algn="l" pos="9387000"/>
                <a:tab algn="l" pos="10429920"/>
              </a:tabLst>
            </a:pPr>
            <a:r>
              <a:rPr b="0" lang="en-US" sz="37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700" spc="-1" strike="noStrike">
              <a:solidFill>
                <a:srgbClr val="000000"/>
              </a:solidFill>
              <a:latin typeface="Calibri"/>
            </a:endParaRPr>
          </a:p>
          <a:p>
            <a:pPr lvl="1" marL="846000" indent="-325440">
              <a:spcBef>
                <a:spcPts val="924"/>
              </a:spcBef>
              <a:buClr>
                <a:srgbClr val="000000"/>
              </a:buClr>
              <a:buFont typeface="Arial"/>
              <a:buChar char="–"/>
              <a:tabLst>
                <a:tab algn="l" pos="1042920"/>
                <a:tab algn="l" pos="2085840"/>
                <a:tab algn="l" pos="3129120"/>
                <a:tab algn="l" pos="4172040"/>
                <a:tab algn="l" pos="5214960"/>
                <a:tab algn="l" pos="6257880"/>
                <a:tab algn="l" pos="7300800"/>
                <a:tab algn="l" pos="8344080"/>
                <a:tab algn="l" pos="9387000"/>
                <a:tab algn="l" pos="10429920"/>
              </a:tabLst>
            </a:pPr>
            <a:r>
              <a:rPr b="0" lang="en-US" sz="37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700" spc="-1" strike="noStrike">
              <a:solidFill>
                <a:srgbClr val="000000"/>
              </a:solidFill>
              <a:latin typeface="Calibri"/>
            </a:endParaRPr>
          </a:p>
          <a:p>
            <a:pPr lvl="2" marL="1303200" indent="-260280">
              <a:spcBef>
                <a:spcPts val="924"/>
              </a:spcBef>
              <a:buClr>
                <a:srgbClr val="000000"/>
              </a:buClr>
              <a:buFont typeface="Arial"/>
              <a:buChar char="•"/>
              <a:tabLst>
                <a:tab algn="l" pos="1042920"/>
                <a:tab algn="l" pos="2085840"/>
                <a:tab algn="l" pos="3129120"/>
                <a:tab algn="l" pos="4172040"/>
                <a:tab algn="l" pos="5214960"/>
                <a:tab algn="l" pos="6257880"/>
                <a:tab algn="l" pos="7300800"/>
                <a:tab algn="l" pos="8344080"/>
                <a:tab algn="l" pos="9387000"/>
                <a:tab algn="l" pos="10429920"/>
              </a:tabLst>
            </a:pPr>
            <a:r>
              <a:rPr b="0" lang="en-US" sz="37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700" spc="-1" strike="noStrike">
              <a:solidFill>
                <a:srgbClr val="000000"/>
              </a:solidFill>
              <a:latin typeface="Calibri"/>
            </a:endParaRPr>
          </a:p>
          <a:p>
            <a:pPr lvl="3" marL="1824120" indent="-260280">
              <a:spcBef>
                <a:spcPts val="924"/>
              </a:spcBef>
              <a:buClr>
                <a:srgbClr val="000000"/>
              </a:buClr>
              <a:buFont typeface="Arial"/>
              <a:buChar char="–"/>
              <a:tabLst>
                <a:tab algn="l" pos="1042920"/>
                <a:tab algn="l" pos="2085840"/>
                <a:tab algn="l" pos="3129120"/>
                <a:tab algn="l" pos="4172040"/>
                <a:tab algn="l" pos="5214960"/>
                <a:tab algn="l" pos="6257880"/>
                <a:tab algn="l" pos="7300800"/>
                <a:tab algn="l" pos="8344080"/>
                <a:tab algn="l" pos="9387000"/>
                <a:tab algn="l" pos="10429920"/>
              </a:tabLst>
            </a:pPr>
            <a:r>
              <a:rPr b="0" lang="en-US" sz="37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700" spc="-1" strike="noStrike">
              <a:solidFill>
                <a:srgbClr val="000000"/>
              </a:solidFill>
              <a:latin typeface="Calibri"/>
            </a:endParaRPr>
          </a:p>
          <a:p>
            <a:pPr lvl="4" marL="2346480" indent="-260640">
              <a:spcBef>
                <a:spcPts val="924"/>
              </a:spcBef>
              <a:buClr>
                <a:srgbClr val="000000"/>
              </a:buClr>
              <a:buFont typeface="Arial"/>
              <a:buChar char="»"/>
              <a:tabLst>
                <a:tab algn="l" pos="1042920"/>
                <a:tab algn="l" pos="2085840"/>
                <a:tab algn="l" pos="3129120"/>
                <a:tab algn="l" pos="4172040"/>
                <a:tab algn="l" pos="5214960"/>
                <a:tab algn="l" pos="6257880"/>
                <a:tab algn="l" pos="7300800"/>
                <a:tab algn="l" pos="8344080"/>
                <a:tab algn="l" pos="9387000"/>
                <a:tab algn="l" pos="10429920"/>
              </a:tabLst>
            </a:pPr>
            <a:r>
              <a:rPr b="0" lang="en-US" sz="37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700" spc="-1" strike="noStrike">
              <a:solidFill>
                <a:srgbClr val="000000"/>
              </a:solidFill>
              <a:latin typeface="Calibri"/>
            </a:endParaRPr>
          </a:p>
          <a:p>
            <a:pPr lvl="5" marL="2346480" indent="-260640">
              <a:spcBef>
                <a:spcPts val="924"/>
              </a:spcBef>
              <a:buClr>
                <a:srgbClr val="000000"/>
              </a:buClr>
              <a:buFont typeface="Arial"/>
              <a:buChar char="»"/>
              <a:tabLst>
                <a:tab algn="l" pos="1042920"/>
                <a:tab algn="l" pos="2085840"/>
                <a:tab algn="l" pos="3129120"/>
                <a:tab algn="l" pos="4172040"/>
                <a:tab algn="l" pos="5214960"/>
                <a:tab algn="l" pos="6257880"/>
                <a:tab algn="l" pos="7300800"/>
                <a:tab algn="l" pos="8344080"/>
                <a:tab algn="l" pos="9387000"/>
                <a:tab algn="l" pos="10429920"/>
              </a:tabLst>
            </a:pPr>
            <a:r>
              <a:rPr b="0" lang="en-US" sz="37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700" spc="-1" strike="noStrike">
              <a:solidFill>
                <a:srgbClr val="000000"/>
              </a:solidFill>
              <a:latin typeface="Calibri"/>
            </a:endParaRPr>
          </a:p>
          <a:p>
            <a:pPr lvl="6" marL="2346480" indent="-260640">
              <a:spcBef>
                <a:spcPts val="924"/>
              </a:spcBef>
              <a:buClr>
                <a:srgbClr val="000000"/>
              </a:buClr>
              <a:buFont typeface="Arial"/>
              <a:buChar char="»"/>
              <a:tabLst>
                <a:tab algn="l" pos="1042920"/>
                <a:tab algn="l" pos="2085840"/>
                <a:tab algn="l" pos="3129120"/>
                <a:tab algn="l" pos="4172040"/>
                <a:tab algn="l" pos="5214960"/>
                <a:tab algn="l" pos="6257880"/>
                <a:tab algn="l" pos="7300800"/>
                <a:tab algn="l" pos="8344080"/>
                <a:tab algn="l" pos="9387000"/>
                <a:tab algn="l" pos="10429920"/>
              </a:tabLst>
            </a:pPr>
            <a:r>
              <a:rPr b="0" lang="en-US" sz="37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77640" y="9911880"/>
            <a:ext cx="1765080" cy="568440"/>
          </a:xfrm>
          <a:prstGeom prst="rect">
            <a:avLst/>
          </a:prstGeom>
          <a:noFill/>
          <a:ln w="0">
            <a:noFill/>
          </a:ln>
        </p:spPr>
        <p:txBody>
          <a:bodyPr lIns="104400" rIns="104400" tIns="52200" bIns="522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1042920"/>
                <a:tab algn="l" pos="2085840"/>
                <a:tab algn="l" pos="3129120"/>
                <a:tab algn="l" pos="4172040"/>
                <a:tab algn="l" pos="5214960"/>
                <a:tab algn="l" pos="6257880"/>
                <a:tab algn="l" pos="7300800"/>
                <a:tab algn="l" pos="8344080"/>
                <a:tab algn="l" pos="9387000"/>
                <a:tab algn="l" pos="10429920"/>
              </a:tabLst>
              <a:defRPr b="0" lang="en-US" sz="14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1042920"/>
                <a:tab algn="l" pos="2085840"/>
                <a:tab algn="l" pos="3129120"/>
                <a:tab algn="l" pos="4172040"/>
                <a:tab algn="l" pos="5214960"/>
                <a:tab algn="l" pos="6257880"/>
                <a:tab algn="l" pos="7300800"/>
                <a:tab algn="l" pos="8344080"/>
                <a:tab algn="l" pos="9387000"/>
                <a:tab algn="l" pos="10429920"/>
              </a:tabLst>
            </a:pPr>
            <a:r>
              <a:rPr b="0" lang="en-US" sz="14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583000" y="9911880"/>
            <a:ext cx="2395440" cy="568440"/>
          </a:xfrm>
          <a:prstGeom prst="rect">
            <a:avLst/>
          </a:prstGeom>
          <a:noFill/>
          <a:ln w="0">
            <a:noFill/>
          </a:ln>
        </p:spPr>
        <p:txBody>
          <a:bodyPr lIns="104400" rIns="104400" tIns="52200" bIns="52200" anchor="ctr">
            <a:noAutofit/>
          </a:bodyPr>
          <a:p>
            <a:pPr indent="0">
              <a:buNone/>
              <a:tabLst>
                <a:tab algn="l" pos="0"/>
                <a:tab algn="l" pos="1042920"/>
                <a:tab algn="l" pos="2085840"/>
                <a:tab algn="l" pos="3129120"/>
                <a:tab algn="l" pos="4172040"/>
                <a:tab algn="l" pos="5214960"/>
                <a:tab algn="l" pos="6257880"/>
                <a:tab algn="l" pos="7300800"/>
                <a:tab algn="l" pos="8344080"/>
                <a:tab algn="l" pos="9387000"/>
                <a:tab algn="l" pos="1042992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5418000" y="9911880"/>
            <a:ext cx="1765440" cy="568440"/>
          </a:xfrm>
          <a:prstGeom prst="rect">
            <a:avLst/>
          </a:prstGeom>
          <a:noFill/>
          <a:ln w="0">
            <a:noFill/>
          </a:ln>
        </p:spPr>
        <p:txBody>
          <a:bodyPr lIns="104400" rIns="104400" tIns="52200" bIns="522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1042920"/>
                <a:tab algn="l" pos="2085840"/>
                <a:tab algn="l" pos="3129120"/>
                <a:tab algn="l" pos="4172040"/>
                <a:tab algn="l" pos="5214960"/>
                <a:tab algn="l" pos="6257880"/>
                <a:tab algn="l" pos="7300800"/>
                <a:tab algn="l" pos="8344080"/>
                <a:tab algn="l" pos="9387000"/>
                <a:tab algn="l" pos="10429920"/>
              </a:tabLst>
              <a:defRPr b="0" lang="en-US" sz="14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1042920"/>
                <a:tab algn="l" pos="2085840"/>
                <a:tab algn="l" pos="3129120"/>
                <a:tab algn="l" pos="4172040"/>
                <a:tab algn="l" pos="5214960"/>
                <a:tab algn="l" pos="6257880"/>
                <a:tab algn="l" pos="7300800"/>
                <a:tab algn="l" pos="8344080"/>
                <a:tab algn="l" pos="9387000"/>
                <a:tab algn="l" pos="10429920"/>
              </a:tabLst>
            </a:pPr>
            <a:fld id="{C0A03095-4A37-4590-B3A9-EE8916B94E02}" type="slidenum">
              <a:rPr b="0" lang="en-US" sz="14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image" Target="../media/image5.png"/><Relationship Id="rId6" Type="http://schemas.openxmlformats.org/officeDocument/2006/relationships/image" Target="../media/image6.png"/><Relationship Id="rId7" Type="http://schemas.openxmlformats.org/officeDocument/2006/relationships/image" Target="../media/image7.png"/><Relationship Id="rId8" Type="http://schemas.openxmlformats.org/officeDocument/2006/relationships/image" Target="../media/image8.png"/><Relationship Id="rId9" Type="http://schemas.openxmlformats.org/officeDocument/2006/relationships/image" Target="../media/image9.png"/><Relationship Id="rId10" Type="http://schemas.openxmlformats.org/officeDocument/2006/relationships/image" Target="../media/image10.png"/><Relationship Id="rId11" Type="http://schemas.openxmlformats.org/officeDocument/2006/relationships/image" Target="../media/image11.png"/><Relationship Id="rId12" Type="http://schemas.openxmlformats.org/officeDocument/2006/relationships/image" Target="../media/image12.png"/><Relationship Id="rId13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Group 8274"/>
          <p:cNvGrpSpPr/>
          <p:nvPr/>
        </p:nvGrpSpPr>
        <p:grpSpPr>
          <a:xfrm>
            <a:off x="457200" y="1117800"/>
            <a:ext cx="6436440" cy="2827440"/>
            <a:chOff x="457200" y="1117800"/>
            <a:chExt cx="6436440" cy="2827440"/>
          </a:xfrm>
        </p:grpSpPr>
        <p:sp>
          <p:nvSpPr>
            <p:cNvPr id="42" name="Rectangle 168"/>
            <p:cNvSpPr/>
            <p:nvPr/>
          </p:nvSpPr>
          <p:spPr>
            <a:xfrm>
              <a:off x="4889160" y="1151280"/>
              <a:ext cx="184464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1042920"/>
                  <a:tab algn="l" pos="2085840"/>
                  <a:tab algn="l" pos="3129120"/>
                  <a:tab algn="l" pos="4172040"/>
                  <a:tab algn="l" pos="5214960"/>
                  <a:tab algn="l" pos="6257880"/>
                  <a:tab algn="l" pos="7300800"/>
                  <a:tab algn="l" pos="8344080"/>
                  <a:tab algn="l" pos="9387000"/>
                  <a:tab algn="l" pos="1042992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Ages 12-13 in 4 countries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43" name="Group 208"/>
            <p:cNvGrpSpPr/>
            <p:nvPr/>
          </p:nvGrpSpPr>
          <p:grpSpPr>
            <a:xfrm>
              <a:off x="644760" y="3259800"/>
              <a:ext cx="6248880" cy="685440"/>
              <a:chOff x="644760" y="3259800"/>
              <a:chExt cx="6248880" cy="685440"/>
            </a:xfrm>
          </p:grpSpPr>
          <p:sp>
            <p:nvSpPr>
              <p:cNvPr id="44" name="Rectangle 161"/>
              <p:cNvSpPr/>
              <p:nvPr/>
            </p:nvSpPr>
            <p:spPr>
              <a:xfrm rot="19800000">
                <a:off x="4287240" y="3567960"/>
                <a:ext cx="832320" cy="137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spAutoFit/>
              </a:bodyPr>
              <a:p>
                <a:pPr>
                  <a:tabLst>
                    <a:tab algn="l" pos="0"/>
                    <a:tab algn="l" pos="1042920"/>
                    <a:tab algn="l" pos="2085840"/>
                    <a:tab algn="l" pos="3129120"/>
                    <a:tab algn="l" pos="4172040"/>
                    <a:tab algn="l" pos="5214960"/>
                    <a:tab algn="l" pos="6257880"/>
                    <a:tab algn="l" pos="7300800"/>
                    <a:tab algn="l" pos="8344080"/>
                    <a:tab algn="l" pos="9387000"/>
                    <a:tab algn="l" pos="1042992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Arial"/>
                  </a:rPr>
                  <a:t>Pelotas, Brazil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5" name="Rectangle 163"/>
              <p:cNvSpPr/>
              <p:nvPr/>
            </p:nvSpPr>
            <p:spPr>
              <a:xfrm rot="19800000">
                <a:off x="4863960" y="3531960"/>
                <a:ext cx="754560" cy="137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spAutoFit/>
              </a:bodyPr>
              <a:p>
                <a:pPr>
                  <a:tabLst>
                    <a:tab algn="l" pos="0"/>
                    <a:tab algn="l" pos="1042920"/>
                    <a:tab algn="l" pos="2085840"/>
                    <a:tab algn="l" pos="3129120"/>
                    <a:tab algn="l" pos="4172040"/>
                    <a:tab algn="l" pos="5214960"/>
                    <a:tab algn="l" pos="6257880"/>
                    <a:tab algn="l" pos="7300800"/>
                    <a:tab algn="l" pos="8344080"/>
                    <a:tab algn="l" pos="9387000"/>
                    <a:tab algn="l" pos="1042992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Arial"/>
                  </a:rPr>
                  <a:t>USA national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6" name="Rectangle 165"/>
              <p:cNvSpPr/>
              <p:nvPr/>
            </p:nvSpPr>
            <p:spPr>
              <a:xfrm rot="19800000">
                <a:off x="5520600" y="3457800"/>
                <a:ext cx="708120" cy="2746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spAutoFit/>
              </a:bodyPr>
              <a:p>
                <a:pPr>
                  <a:tabLst>
                    <a:tab algn="l" pos="0"/>
                    <a:tab algn="l" pos="1042920"/>
                    <a:tab algn="l" pos="2085840"/>
                    <a:tab algn="l" pos="3129120"/>
                    <a:tab algn="l" pos="4172040"/>
                    <a:tab algn="l" pos="5214960"/>
                    <a:tab algn="l" pos="6257880"/>
                    <a:tab algn="l" pos="7300800"/>
                    <a:tab algn="l" pos="8344080"/>
                    <a:tab algn="l" pos="9387000"/>
                    <a:tab algn="l" pos="1042992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Arial"/>
                  </a:rPr>
                  <a:t>Southwest 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tabLst>
                    <a:tab algn="l" pos="0"/>
                    <a:tab algn="l" pos="1042920"/>
                    <a:tab algn="l" pos="2085840"/>
                    <a:tab algn="l" pos="3129120"/>
                    <a:tab algn="l" pos="4172040"/>
                    <a:tab algn="l" pos="5214960"/>
                    <a:tab algn="l" pos="6257880"/>
                    <a:tab algn="l" pos="7300800"/>
                    <a:tab algn="l" pos="8344080"/>
                    <a:tab algn="l" pos="9387000"/>
                    <a:tab algn="l" pos="1042992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Arial"/>
                  </a:rPr>
                  <a:t>England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7" name="Rectangle 167"/>
              <p:cNvSpPr/>
              <p:nvPr/>
            </p:nvSpPr>
            <p:spPr>
              <a:xfrm rot="19800000">
                <a:off x="6138720" y="3425040"/>
                <a:ext cx="735120" cy="2746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spAutoFit/>
              </a:bodyPr>
              <a:p>
                <a:pPr>
                  <a:tabLst>
                    <a:tab algn="l" pos="0"/>
                    <a:tab algn="l" pos="1042920"/>
                    <a:tab algn="l" pos="2085840"/>
                    <a:tab algn="l" pos="3129120"/>
                    <a:tab algn="l" pos="4172040"/>
                    <a:tab algn="l" pos="5214960"/>
                    <a:tab algn="l" pos="6257880"/>
                    <a:tab algn="l" pos="7300800"/>
                    <a:tab algn="l" pos="8344080"/>
                    <a:tab algn="l" pos="9387000"/>
                    <a:tab algn="l" pos="1042992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Arial"/>
                  </a:rPr>
                  <a:t>Melbourne, Australia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8" name="Rectangle 220"/>
              <p:cNvSpPr/>
              <p:nvPr/>
            </p:nvSpPr>
            <p:spPr>
              <a:xfrm rot="19800000">
                <a:off x="647280" y="3441600"/>
                <a:ext cx="471240" cy="137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spAutoFit/>
              </a:bodyPr>
              <a:p>
                <a:pPr>
                  <a:tabLst>
                    <a:tab algn="l" pos="0"/>
                    <a:tab algn="l" pos="1042920"/>
                    <a:tab algn="l" pos="2085840"/>
                    <a:tab algn="l" pos="3129120"/>
                    <a:tab algn="l" pos="4172040"/>
                    <a:tab algn="l" pos="5214960"/>
                    <a:tab algn="l" pos="6257880"/>
                    <a:tab algn="l" pos="7300800"/>
                    <a:tab algn="l" pos="8344080"/>
                    <a:tab algn="l" pos="9387000"/>
                    <a:tab algn="l" pos="1042992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Arial"/>
                  </a:rPr>
                  <a:t>Madeira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9" name="Rectangle 222"/>
              <p:cNvSpPr/>
              <p:nvPr/>
            </p:nvSpPr>
            <p:spPr>
              <a:xfrm rot="19800000">
                <a:off x="1017720" y="3488760"/>
                <a:ext cx="730080" cy="137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spAutoFit/>
              </a:bodyPr>
              <a:p>
                <a:pPr>
                  <a:tabLst>
                    <a:tab algn="l" pos="0"/>
                    <a:tab algn="l" pos="1042920"/>
                    <a:tab algn="l" pos="2085840"/>
                    <a:tab algn="l" pos="3129120"/>
                    <a:tab algn="l" pos="4172040"/>
                    <a:tab algn="l" pos="5214960"/>
                    <a:tab algn="l" pos="6257880"/>
                    <a:tab algn="l" pos="7300800"/>
                    <a:tab algn="l" pos="8344080"/>
                    <a:tab algn="l" pos="9387000"/>
                    <a:tab algn="l" pos="1042992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Arial"/>
                  </a:rPr>
                  <a:t>USA national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0" name="Rectangle 224"/>
              <p:cNvSpPr/>
              <p:nvPr/>
            </p:nvSpPr>
            <p:spPr>
              <a:xfrm rot="19800000">
                <a:off x="1378080" y="3567600"/>
                <a:ext cx="874800" cy="137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spAutoFit/>
              </a:bodyPr>
              <a:p>
                <a:pPr>
                  <a:tabLst>
                    <a:tab algn="l" pos="0"/>
                    <a:tab algn="l" pos="1042920"/>
                    <a:tab algn="l" pos="2085840"/>
                    <a:tab algn="l" pos="3129120"/>
                    <a:tab algn="l" pos="4172040"/>
                    <a:tab algn="l" pos="5214960"/>
                    <a:tab algn="l" pos="6257880"/>
                    <a:tab algn="l" pos="7300800"/>
                    <a:tab algn="l" pos="8344080"/>
                    <a:tab algn="l" pos="9387000"/>
                    <a:tab algn="l" pos="1042992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Arial"/>
                  </a:rPr>
                  <a:t>East of England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1" name="Rectangle 226"/>
              <p:cNvSpPr/>
              <p:nvPr/>
            </p:nvSpPr>
            <p:spPr>
              <a:xfrm rot="19800000">
                <a:off x="1802160" y="3567960"/>
                <a:ext cx="995400" cy="137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spAutoFit/>
              </a:bodyPr>
              <a:p>
                <a:pPr>
                  <a:tabLst>
                    <a:tab algn="l" pos="0"/>
                    <a:tab algn="l" pos="1042920"/>
                    <a:tab algn="l" pos="2085840"/>
                    <a:tab algn="l" pos="3129120"/>
                    <a:tab algn="l" pos="4172040"/>
                    <a:tab algn="l" pos="5214960"/>
                    <a:tab algn="l" pos="6257880"/>
                    <a:tab algn="l" pos="7300800"/>
                    <a:tab algn="l" pos="8344080"/>
                    <a:tab algn="l" pos="9387000"/>
                    <a:tab algn="l" pos="1042992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Arial"/>
                  </a:rPr>
                  <a:t>Odense, Denmark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2" name="Rectangle 228"/>
              <p:cNvSpPr/>
              <p:nvPr/>
            </p:nvSpPr>
            <p:spPr>
              <a:xfrm rot="19800000">
                <a:off x="2598840" y="3466800"/>
                <a:ext cx="744120" cy="2746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spAutoFit/>
              </a:bodyPr>
              <a:p>
                <a:pPr>
                  <a:tabLst>
                    <a:tab algn="l" pos="0"/>
                    <a:tab algn="l" pos="1042920"/>
                    <a:tab algn="l" pos="2085840"/>
                    <a:tab algn="l" pos="3129120"/>
                    <a:tab algn="l" pos="4172040"/>
                    <a:tab algn="l" pos="5214960"/>
                    <a:tab algn="l" pos="6257880"/>
                    <a:tab algn="l" pos="7300800"/>
                    <a:tab algn="l" pos="8344080"/>
                    <a:tab algn="l" pos="9387000"/>
                    <a:tab algn="l" pos="1042992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Arial"/>
                  </a:rPr>
                  <a:t>Melbourne, 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tabLst>
                    <a:tab algn="l" pos="0"/>
                    <a:tab algn="l" pos="1042920"/>
                    <a:tab algn="l" pos="2085840"/>
                    <a:tab algn="l" pos="3129120"/>
                    <a:tab algn="l" pos="4172040"/>
                    <a:tab algn="l" pos="5214960"/>
                    <a:tab algn="l" pos="6257880"/>
                    <a:tab algn="l" pos="7300800"/>
                    <a:tab algn="l" pos="8344080"/>
                    <a:tab algn="l" pos="9387000"/>
                    <a:tab algn="l" pos="1042992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Arial"/>
                  </a:rPr>
                  <a:t>Australia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3" name="Rectangle 230"/>
              <p:cNvSpPr/>
              <p:nvPr/>
            </p:nvSpPr>
            <p:spPr>
              <a:xfrm rot="19800000">
                <a:off x="3083760" y="3499920"/>
                <a:ext cx="776160" cy="137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spAutoFit/>
              </a:bodyPr>
              <a:p>
                <a:pPr>
                  <a:tabLst>
                    <a:tab algn="l" pos="0"/>
                    <a:tab algn="l" pos="1042920"/>
                    <a:tab algn="l" pos="2085840"/>
                    <a:tab algn="l" pos="3129120"/>
                    <a:tab algn="l" pos="4172040"/>
                    <a:tab algn="l" pos="5214960"/>
                    <a:tab algn="l" pos="6257880"/>
                    <a:tab algn="l" pos="7300800"/>
                    <a:tab algn="l" pos="8344080"/>
                    <a:tab algn="l" pos="9387000"/>
                    <a:tab algn="l" pos="1042992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Arial"/>
                  </a:rPr>
                  <a:t>Tartu, Estonia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4" name="Rectangle 232"/>
              <p:cNvSpPr/>
              <p:nvPr/>
            </p:nvSpPr>
            <p:spPr>
              <a:xfrm rot="19800000">
                <a:off x="3617280" y="3492720"/>
                <a:ext cx="746280" cy="137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spAutoFit/>
              </a:bodyPr>
              <a:p>
                <a:pPr>
                  <a:tabLst>
                    <a:tab algn="l" pos="0"/>
                    <a:tab algn="l" pos="1042920"/>
                    <a:tab algn="l" pos="2085840"/>
                    <a:tab algn="l" pos="3129120"/>
                    <a:tab algn="l" pos="4172040"/>
                    <a:tab algn="l" pos="5214960"/>
                    <a:tab algn="l" pos="6257880"/>
                    <a:tab algn="l" pos="7300800"/>
                    <a:tab algn="l" pos="8344080"/>
                    <a:tab algn="l" pos="9387000"/>
                    <a:tab algn="l" pos="1042992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Arial"/>
                  </a:rPr>
                  <a:t>Oslo, Norway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55" name="Rectangle 233"/>
            <p:cNvSpPr/>
            <p:nvPr/>
          </p:nvSpPr>
          <p:spPr>
            <a:xfrm>
              <a:off x="1765440" y="1151280"/>
              <a:ext cx="175932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1042920"/>
                  <a:tab algn="l" pos="2085840"/>
                  <a:tab algn="l" pos="3129120"/>
                  <a:tab algn="l" pos="4172040"/>
                  <a:tab algn="l" pos="5214960"/>
                  <a:tab algn="l" pos="6257880"/>
                  <a:tab algn="l" pos="7300800"/>
                  <a:tab algn="l" pos="8344080"/>
                  <a:tab algn="l" pos="9387000"/>
                  <a:tab algn="l" pos="1042992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Ages 9-10 in 7 countries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56" name="Group 676"/>
            <p:cNvGrpSpPr/>
            <p:nvPr/>
          </p:nvGrpSpPr>
          <p:grpSpPr>
            <a:xfrm>
              <a:off x="955440" y="1235160"/>
              <a:ext cx="713520" cy="404640"/>
              <a:chOff x="955440" y="1235160"/>
              <a:chExt cx="713520" cy="404640"/>
            </a:xfrm>
          </p:grpSpPr>
          <p:grpSp>
            <p:nvGrpSpPr>
              <p:cNvPr id="57" name="Rectangle 193"/>
              <p:cNvGrpSpPr/>
              <p:nvPr/>
            </p:nvGrpSpPr>
            <p:grpSpPr>
              <a:xfrm>
                <a:off x="955440" y="1450440"/>
                <a:ext cx="193680" cy="189360"/>
                <a:chOff x="955440" y="1450440"/>
                <a:chExt cx="193680" cy="189360"/>
              </a:xfrm>
            </p:grpSpPr>
            <p:pic>
              <p:nvPicPr>
                <p:cNvPr id="58" name="Rectangle 193" descr=""/>
                <p:cNvPicPr/>
                <p:nvPr/>
              </p:nvPicPr>
              <p:blipFill>
                <a:blip r:embed="rId1"/>
                <a:stretch/>
              </p:blipFill>
              <p:spPr>
                <a:xfrm>
                  <a:off x="955440" y="1450440"/>
                  <a:ext cx="193680" cy="189360"/>
                </a:xfrm>
                <a:prstGeom prst="rect">
                  <a:avLst/>
                </a:prstGeom>
                <a:ln w="0">
                  <a:noFill/>
                </a:ln>
              </p:spPr>
            </p:pic>
            <p:sp>
              <p:nvSpPr>
                <p:cNvPr id="59" name=""/>
                <p:cNvSpPr/>
                <p:nvPr/>
              </p:nvSpPr>
              <p:spPr>
                <a:xfrm>
                  <a:off x="959760" y="1453320"/>
                  <a:ext cx="179280" cy="1742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pPr>
                    <a:tabLst>
                      <a:tab algn="l" pos="0"/>
                      <a:tab algn="l" pos="1042920"/>
                      <a:tab algn="l" pos="2085840"/>
                      <a:tab algn="l" pos="3129120"/>
                      <a:tab algn="l" pos="4172040"/>
                      <a:tab algn="l" pos="5214960"/>
                      <a:tab algn="l" pos="6257880"/>
                      <a:tab algn="l" pos="7300800"/>
                      <a:tab algn="l" pos="8344080"/>
                      <a:tab algn="l" pos="9387000"/>
                      <a:tab algn="l" pos="10429920"/>
                    </a:tabLst>
                  </a:pPr>
                  <a:endParaRPr b="0" lang="en-US" sz="21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sp>
            <p:nvSpPr>
              <p:cNvPr id="60" name="Rectangle 179"/>
              <p:cNvSpPr/>
              <p:nvPr/>
            </p:nvSpPr>
            <p:spPr>
              <a:xfrm>
                <a:off x="959760" y="1235160"/>
                <a:ext cx="179280" cy="174240"/>
              </a:xfrm>
              <a:prstGeom prst="rect">
                <a:avLst/>
              </a:prstGeom>
              <a:solidFill>
                <a:srgbClr val="595959"/>
              </a:solidFill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1042920"/>
                    <a:tab algn="l" pos="2085840"/>
                    <a:tab algn="l" pos="3129120"/>
                    <a:tab algn="l" pos="4172040"/>
                    <a:tab algn="l" pos="5214960"/>
                    <a:tab algn="l" pos="6257880"/>
                    <a:tab algn="l" pos="7300800"/>
                    <a:tab algn="l" pos="8344080"/>
                    <a:tab algn="l" pos="9387000"/>
                    <a:tab algn="l" pos="10429920"/>
                  </a:tabLst>
                </a:pPr>
                <a:endParaRPr b="0" lang="en-US" sz="21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1" name="Rectangle 226"/>
              <p:cNvSpPr/>
              <p:nvPr/>
            </p:nvSpPr>
            <p:spPr>
              <a:xfrm>
                <a:off x="1247400" y="1235160"/>
                <a:ext cx="27360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1042920"/>
                    <a:tab algn="l" pos="2085840"/>
                    <a:tab algn="l" pos="3129120"/>
                    <a:tab algn="l" pos="4172040"/>
                    <a:tab algn="l" pos="5214960"/>
                    <a:tab algn="l" pos="6257880"/>
                    <a:tab algn="l" pos="7300800"/>
                    <a:tab algn="l" pos="8344080"/>
                    <a:tab algn="l" pos="9387000"/>
                    <a:tab algn="l" pos="1042992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Male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2" name="Rectangle 226"/>
              <p:cNvSpPr/>
              <p:nvPr/>
            </p:nvSpPr>
            <p:spPr>
              <a:xfrm>
                <a:off x="1247760" y="1443960"/>
                <a:ext cx="42120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1042920"/>
                    <a:tab algn="l" pos="2085840"/>
                    <a:tab algn="l" pos="3129120"/>
                    <a:tab algn="l" pos="4172040"/>
                    <a:tab algn="l" pos="5214960"/>
                    <a:tab algn="l" pos="6257880"/>
                    <a:tab algn="l" pos="7300800"/>
                    <a:tab algn="l" pos="8344080"/>
                    <a:tab algn="l" pos="9387000"/>
                    <a:tab algn="l" pos="1042992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Female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63" name="Rectangle 133"/>
            <p:cNvSpPr/>
            <p:nvPr/>
          </p:nvSpPr>
          <p:spPr>
            <a:xfrm>
              <a:off x="825120" y="2046240"/>
              <a:ext cx="174600" cy="1261800"/>
            </a:xfrm>
            <a:prstGeom prst="rect">
              <a:avLst/>
            </a:prstGeom>
            <a:solidFill>
              <a:srgbClr val="595959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" name="Rectangle 134"/>
            <p:cNvSpPr/>
            <p:nvPr/>
          </p:nvSpPr>
          <p:spPr>
            <a:xfrm>
              <a:off x="1347480" y="2016000"/>
              <a:ext cx="172800" cy="1292040"/>
            </a:xfrm>
            <a:prstGeom prst="rect">
              <a:avLst/>
            </a:prstGeom>
            <a:solidFill>
              <a:srgbClr val="595959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" name="Rectangle 135"/>
            <p:cNvSpPr/>
            <p:nvPr/>
          </p:nvSpPr>
          <p:spPr>
            <a:xfrm>
              <a:off x="1871640" y="1942920"/>
              <a:ext cx="172800" cy="1365120"/>
            </a:xfrm>
            <a:prstGeom prst="rect">
              <a:avLst/>
            </a:prstGeom>
            <a:solidFill>
              <a:srgbClr val="595959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" name="Rectangle 136"/>
            <p:cNvSpPr/>
            <p:nvPr/>
          </p:nvSpPr>
          <p:spPr>
            <a:xfrm>
              <a:off x="2392200" y="1830240"/>
              <a:ext cx="171360" cy="1477800"/>
            </a:xfrm>
            <a:prstGeom prst="rect">
              <a:avLst/>
            </a:prstGeom>
            <a:solidFill>
              <a:srgbClr val="595959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" name="Rectangle 137"/>
            <p:cNvSpPr/>
            <p:nvPr/>
          </p:nvSpPr>
          <p:spPr>
            <a:xfrm>
              <a:off x="2914560" y="1654200"/>
              <a:ext cx="169560" cy="1653840"/>
            </a:xfrm>
            <a:prstGeom prst="rect">
              <a:avLst/>
            </a:prstGeom>
            <a:solidFill>
              <a:srgbClr val="595959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" name="Rectangle 138"/>
            <p:cNvSpPr/>
            <p:nvPr/>
          </p:nvSpPr>
          <p:spPr>
            <a:xfrm>
              <a:off x="3435480" y="1571760"/>
              <a:ext cx="171360" cy="1736280"/>
            </a:xfrm>
            <a:prstGeom prst="rect">
              <a:avLst/>
            </a:prstGeom>
            <a:solidFill>
              <a:srgbClr val="595959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" name="Rectangle 139"/>
            <p:cNvSpPr/>
            <p:nvPr/>
          </p:nvSpPr>
          <p:spPr>
            <a:xfrm>
              <a:off x="3956040" y="1584360"/>
              <a:ext cx="174600" cy="1723680"/>
            </a:xfrm>
            <a:prstGeom prst="rect">
              <a:avLst/>
            </a:prstGeom>
            <a:solidFill>
              <a:srgbClr val="595959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0" name="Line 140"/>
            <p:cNvSpPr/>
            <p:nvPr/>
          </p:nvSpPr>
          <p:spPr>
            <a:xfrm flipV="1">
              <a:off x="914040" y="1952280"/>
              <a:ext cx="0" cy="191880"/>
            </a:xfrm>
            <a:prstGeom prst="line">
              <a:avLst/>
            </a:prstGeom>
            <a:ln w="205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1" name="Line 141"/>
            <p:cNvSpPr/>
            <p:nvPr/>
          </p:nvSpPr>
          <p:spPr>
            <a:xfrm flipV="1">
              <a:off x="1434960" y="1939680"/>
              <a:ext cx="0" cy="152280"/>
            </a:xfrm>
            <a:prstGeom prst="line">
              <a:avLst/>
            </a:prstGeom>
            <a:ln w="205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2" name="Line 142"/>
            <p:cNvSpPr/>
            <p:nvPr/>
          </p:nvSpPr>
          <p:spPr>
            <a:xfrm flipV="1">
              <a:off x="1957320" y="1906200"/>
              <a:ext cx="0" cy="75960"/>
            </a:xfrm>
            <a:prstGeom prst="line">
              <a:avLst/>
            </a:prstGeom>
            <a:ln w="205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9160" bIns="29160" anchor="t">
              <a:noAutofit/>
            </a:bodyPr>
            <a:p>
              <a:endParaRPr b="0" lang="en-US" sz="2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3" name="Line 143"/>
            <p:cNvSpPr/>
            <p:nvPr/>
          </p:nvSpPr>
          <p:spPr>
            <a:xfrm flipV="1">
              <a:off x="2477880" y="1751040"/>
              <a:ext cx="0" cy="158400"/>
            </a:xfrm>
            <a:prstGeom prst="line">
              <a:avLst/>
            </a:prstGeom>
            <a:ln w="205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4" name="Line 144"/>
            <p:cNvSpPr/>
            <p:nvPr/>
          </p:nvSpPr>
          <p:spPr>
            <a:xfrm flipV="1">
              <a:off x="2998800" y="1588680"/>
              <a:ext cx="0" cy="131400"/>
            </a:xfrm>
            <a:prstGeom prst="line">
              <a:avLst/>
            </a:prstGeom>
            <a:ln w="205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5" name="Line 145"/>
            <p:cNvSpPr/>
            <p:nvPr/>
          </p:nvSpPr>
          <p:spPr>
            <a:xfrm flipV="1">
              <a:off x="3521160" y="1428480"/>
              <a:ext cx="0" cy="285480"/>
            </a:xfrm>
            <a:prstGeom prst="line">
              <a:avLst/>
            </a:prstGeom>
            <a:ln w="205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6" name="Line 146"/>
            <p:cNvSpPr/>
            <p:nvPr/>
          </p:nvSpPr>
          <p:spPr>
            <a:xfrm flipV="1">
              <a:off x="4041720" y="1455480"/>
              <a:ext cx="0" cy="255240"/>
            </a:xfrm>
            <a:prstGeom prst="line">
              <a:avLst/>
            </a:prstGeom>
            <a:ln w="205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77" name="Rectangle 147"/>
            <p:cNvGrpSpPr/>
            <p:nvPr/>
          </p:nvGrpSpPr>
          <p:grpSpPr>
            <a:xfrm>
              <a:off x="993600" y="2219040"/>
              <a:ext cx="188640" cy="1103400"/>
              <a:chOff x="993600" y="2219040"/>
              <a:chExt cx="188640" cy="1103400"/>
            </a:xfrm>
          </p:grpSpPr>
          <p:pic>
            <p:nvPicPr>
              <p:cNvPr id="78" name="Rectangle 147" descr=""/>
              <p:cNvPicPr/>
              <p:nvPr/>
            </p:nvPicPr>
            <p:blipFill>
              <a:blip r:embed="rId2"/>
              <a:stretch/>
            </p:blipFill>
            <p:spPr>
              <a:xfrm>
                <a:off x="993600" y="2219040"/>
                <a:ext cx="188640" cy="110340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79" name=""/>
              <p:cNvSpPr/>
              <p:nvPr/>
            </p:nvSpPr>
            <p:spPr>
              <a:xfrm>
                <a:off x="999720" y="2226960"/>
                <a:ext cx="169560" cy="1081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1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80" name="Rectangle 148"/>
            <p:cNvGrpSpPr/>
            <p:nvPr/>
          </p:nvGrpSpPr>
          <p:grpSpPr>
            <a:xfrm>
              <a:off x="1511640" y="2389680"/>
              <a:ext cx="194760" cy="932400"/>
              <a:chOff x="1511640" y="2389680"/>
              <a:chExt cx="194760" cy="932400"/>
            </a:xfrm>
          </p:grpSpPr>
          <p:pic>
            <p:nvPicPr>
              <p:cNvPr id="81" name="Rectangle 148" descr=""/>
              <p:cNvPicPr/>
              <p:nvPr/>
            </p:nvPicPr>
            <p:blipFill>
              <a:blip r:embed="rId3"/>
              <a:stretch/>
            </p:blipFill>
            <p:spPr>
              <a:xfrm>
                <a:off x="1511640" y="2389680"/>
                <a:ext cx="194760" cy="93240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82" name=""/>
              <p:cNvSpPr/>
              <p:nvPr/>
            </p:nvSpPr>
            <p:spPr>
              <a:xfrm>
                <a:off x="1520280" y="2393640"/>
                <a:ext cx="174600" cy="914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1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83" name="Rectangle 149"/>
            <p:cNvGrpSpPr/>
            <p:nvPr/>
          </p:nvGrpSpPr>
          <p:grpSpPr>
            <a:xfrm>
              <a:off x="2035800" y="2365200"/>
              <a:ext cx="194760" cy="956880"/>
              <a:chOff x="2035800" y="2365200"/>
              <a:chExt cx="194760" cy="956880"/>
            </a:xfrm>
          </p:grpSpPr>
          <p:pic>
            <p:nvPicPr>
              <p:cNvPr id="84" name="Rectangle 149" descr=""/>
              <p:cNvPicPr/>
              <p:nvPr/>
            </p:nvPicPr>
            <p:blipFill>
              <a:blip r:embed="rId4"/>
              <a:stretch/>
            </p:blipFill>
            <p:spPr>
              <a:xfrm>
                <a:off x="2035800" y="2365200"/>
                <a:ext cx="194760" cy="95688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85" name=""/>
              <p:cNvSpPr/>
              <p:nvPr/>
            </p:nvSpPr>
            <p:spPr>
              <a:xfrm>
                <a:off x="2044080" y="2369880"/>
                <a:ext cx="171360" cy="9381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1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86" name="Rectangle 150"/>
            <p:cNvGrpSpPr/>
            <p:nvPr/>
          </p:nvGrpSpPr>
          <p:grpSpPr>
            <a:xfrm>
              <a:off x="2560320" y="2261520"/>
              <a:ext cx="188640" cy="1060560"/>
              <a:chOff x="2560320" y="2261520"/>
              <a:chExt cx="188640" cy="1060560"/>
            </a:xfrm>
          </p:grpSpPr>
          <p:pic>
            <p:nvPicPr>
              <p:cNvPr id="87" name="Rectangle 150" descr=""/>
              <p:cNvPicPr/>
              <p:nvPr/>
            </p:nvPicPr>
            <p:blipFill>
              <a:blip r:embed="rId5"/>
              <a:stretch/>
            </p:blipFill>
            <p:spPr>
              <a:xfrm>
                <a:off x="2560320" y="2261520"/>
                <a:ext cx="188640" cy="106056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88" name=""/>
              <p:cNvSpPr/>
              <p:nvPr/>
            </p:nvSpPr>
            <p:spPr>
              <a:xfrm>
                <a:off x="2566800" y="2266560"/>
                <a:ext cx="172800" cy="1041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1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89" name="Rectangle 151"/>
            <p:cNvGrpSpPr/>
            <p:nvPr/>
          </p:nvGrpSpPr>
          <p:grpSpPr>
            <a:xfrm>
              <a:off x="3084480" y="2127600"/>
              <a:ext cx="188640" cy="1194840"/>
              <a:chOff x="3084480" y="2127600"/>
              <a:chExt cx="188640" cy="1194840"/>
            </a:xfrm>
          </p:grpSpPr>
          <p:pic>
            <p:nvPicPr>
              <p:cNvPr id="90" name="Rectangle 151" descr=""/>
              <p:cNvPicPr/>
              <p:nvPr/>
            </p:nvPicPr>
            <p:blipFill>
              <a:blip r:embed="rId6"/>
              <a:stretch/>
            </p:blipFill>
            <p:spPr>
              <a:xfrm>
                <a:off x="3084480" y="2127600"/>
                <a:ext cx="188640" cy="119484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91" name=""/>
              <p:cNvSpPr/>
              <p:nvPr/>
            </p:nvSpPr>
            <p:spPr>
              <a:xfrm>
                <a:off x="3087360" y="2135160"/>
                <a:ext cx="174600" cy="1173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1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92" name="Rectangle 152"/>
            <p:cNvGrpSpPr/>
            <p:nvPr/>
          </p:nvGrpSpPr>
          <p:grpSpPr>
            <a:xfrm>
              <a:off x="3602880" y="2060640"/>
              <a:ext cx="194760" cy="1261800"/>
              <a:chOff x="3602880" y="2060640"/>
              <a:chExt cx="194760" cy="1261800"/>
            </a:xfrm>
          </p:grpSpPr>
          <p:pic>
            <p:nvPicPr>
              <p:cNvPr id="93" name="Rectangle 152" descr=""/>
              <p:cNvPicPr/>
              <p:nvPr/>
            </p:nvPicPr>
            <p:blipFill>
              <a:blip r:embed="rId7"/>
              <a:stretch/>
            </p:blipFill>
            <p:spPr>
              <a:xfrm>
                <a:off x="3602880" y="2060640"/>
                <a:ext cx="194760" cy="126180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94" name=""/>
              <p:cNvSpPr/>
              <p:nvPr/>
            </p:nvSpPr>
            <p:spPr>
              <a:xfrm>
                <a:off x="3610080" y="2068560"/>
                <a:ext cx="172800" cy="12398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1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95" name="Rectangle 153"/>
            <p:cNvGrpSpPr/>
            <p:nvPr/>
          </p:nvGrpSpPr>
          <p:grpSpPr>
            <a:xfrm>
              <a:off x="4127040" y="1999440"/>
              <a:ext cx="188640" cy="1322640"/>
              <a:chOff x="4127040" y="1999440"/>
              <a:chExt cx="188640" cy="1322640"/>
            </a:xfrm>
          </p:grpSpPr>
          <p:pic>
            <p:nvPicPr>
              <p:cNvPr id="96" name="Rectangle 153" descr=""/>
              <p:cNvPicPr/>
              <p:nvPr/>
            </p:nvPicPr>
            <p:blipFill>
              <a:blip r:embed="rId8"/>
              <a:stretch/>
            </p:blipFill>
            <p:spPr>
              <a:xfrm>
                <a:off x="4127040" y="1999440"/>
                <a:ext cx="188640" cy="132264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97" name=""/>
              <p:cNvSpPr/>
              <p:nvPr/>
            </p:nvSpPr>
            <p:spPr>
              <a:xfrm>
                <a:off x="4130640" y="2004840"/>
                <a:ext cx="172800" cy="13032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1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98" name="Line 154"/>
            <p:cNvSpPr/>
            <p:nvPr/>
          </p:nvSpPr>
          <p:spPr>
            <a:xfrm flipV="1">
              <a:off x="1087200" y="2158920"/>
              <a:ext cx="0" cy="134640"/>
            </a:xfrm>
            <a:prstGeom prst="line">
              <a:avLst/>
            </a:prstGeom>
            <a:ln w="205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9" name="Line 155"/>
            <p:cNvSpPr/>
            <p:nvPr/>
          </p:nvSpPr>
          <p:spPr>
            <a:xfrm flipV="1">
              <a:off x="1609560" y="2336400"/>
              <a:ext cx="0" cy="112680"/>
            </a:xfrm>
            <a:prstGeom prst="line">
              <a:avLst/>
            </a:prstGeom>
            <a:ln w="205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0" name="Line 156"/>
            <p:cNvSpPr/>
            <p:nvPr/>
          </p:nvSpPr>
          <p:spPr>
            <a:xfrm flipV="1">
              <a:off x="2130480" y="2346120"/>
              <a:ext cx="0" cy="47520"/>
            </a:xfrm>
            <a:prstGeom prst="line">
              <a:avLst/>
            </a:prstGeom>
            <a:ln w="205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720" bIns="720" anchor="t">
              <a:noAutofit/>
            </a:bodyPr>
            <a:p>
              <a:endParaRPr b="0" lang="en-US" sz="2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1" name="Line 157"/>
            <p:cNvSpPr/>
            <p:nvPr/>
          </p:nvSpPr>
          <p:spPr>
            <a:xfrm flipV="1">
              <a:off x="2652480" y="2211120"/>
              <a:ext cx="0" cy="106200"/>
            </a:xfrm>
            <a:prstGeom prst="line">
              <a:avLst/>
            </a:prstGeom>
            <a:ln w="205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2" name="Line 158"/>
            <p:cNvSpPr/>
            <p:nvPr/>
          </p:nvSpPr>
          <p:spPr>
            <a:xfrm flipV="1">
              <a:off x="3173400" y="2085840"/>
              <a:ext cx="0" cy="95040"/>
            </a:xfrm>
            <a:prstGeom prst="line">
              <a:avLst/>
            </a:prstGeom>
            <a:ln w="205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3" name="Line 159"/>
            <p:cNvSpPr/>
            <p:nvPr/>
          </p:nvSpPr>
          <p:spPr>
            <a:xfrm flipV="1">
              <a:off x="3694320" y="1958400"/>
              <a:ext cx="0" cy="215640"/>
            </a:xfrm>
            <a:prstGeom prst="line">
              <a:avLst/>
            </a:prstGeom>
            <a:ln w="205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4" name="Line 160"/>
            <p:cNvSpPr/>
            <p:nvPr/>
          </p:nvSpPr>
          <p:spPr>
            <a:xfrm flipV="1">
              <a:off x="4216320" y="1909440"/>
              <a:ext cx="0" cy="185400"/>
            </a:xfrm>
            <a:prstGeom prst="line">
              <a:avLst/>
            </a:prstGeom>
            <a:ln w="205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5" name="Line 161"/>
            <p:cNvSpPr/>
            <p:nvPr/>
          </p:nvSpPr>
          <p:spPr>
            <a:xfrm flipV="1">
              <a:off x="768240" y="1180800"/>
              <a:ext cx="0" cy="21920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6" name="Line 162"/>
            <p:cNvSpPr/>
            <p:nvPr/>
          </p:nvSpPr>
          <p:spPr>
            <a:xfrm flipH="1">
              <a:off x="728280" y="3311280"/>
              <a:ext cx="39600" cy="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7" name="Rectangle 163"/>
            <p:cNvSpPr/>
            <p:nvPr/>
          </p:nvSpPr>
          <p:spPr>
            <a:xfrm rot="16200000">
              <a:off x="629640" y="3207240"/>
              <a:ext cx="709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8" name="Line 164"/>
            <p:cNvSpPr/>
            <p:nvPr/>
          </p:nvSpPr>
          <p:spPr>
            <a:xfrm flipH="1">
              <a:off x="728280" y="2966760"/>
              <a:ext cx="39600" cy="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9" name="Rectangle 165"/>
            <p:cNvSpPr/>
            <p:nvPr/>
          </p:nvSpPr>
          <p:spPr>
            <a:xfrm rot="16200000">
              <a:off x="629640" y="2863080"/>
              <a:ext cx="709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2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0" name="Line 166"/>
            <p:cNvSpPr/>
            <p:nvPr/>
          </p:nvSpPr>
          <p:spPr>
            <a:xfrm flipH="1">
              <a:off x="728280" y="2622600"/>
              <a:ext cx="39600" cy="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1" name="Rectangle 167"/>
            <p:cNvSpPr/>
            <p:nvPr/>
          </p:nvSpPr>
          <p:spPr>
            <a:xfrm rot="16200000">
              <a:off x="629640" y="2518560"/>
              <a:ext cx="709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4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2" name="Line 168"/>
            <p:cNvSpPr/>
            <p:nvPr/>
          </p:nvSpPr>
          <p:spPr>
            <a:xfrm flipH="1">
              <a:off x="728280" y="2278080"/>
              <a:ext cx="39600" cy="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3" name="Rectangle 169"/>
            <p:cNvSpPr/>
            <p:nvPr/>
          </p:nvSpPr>
          <p:spPr>
            <a:xfrm rot="16200000">
              <a:off x="629640" y="2174040"/>
              <a:ext cx="709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6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4" name="Line 170"/>
            <p:cNvSpPr/>
            <p:nvPr/>
          </p:nvSpPr>
          <p:spPr>
            <a:xfrm flipH="1">
              <a:off x="728280" y="1930320"/>
              <a:ext cx="39600" cy="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5" name="Rectangle 171"/>
            <p:cNvSpPr/>
            <p:nvPr/>
          </p:nvSpPr>
          <p:spPr>
            <a:xfrm rot="16200000">
              <a:off x="629640" y="1826280"/>
              <a:ext cx="709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8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6" name="Line 172"/>
            <p:cNvSpPr/>
            <p:nvPr/>
          </p:nvSpPr>
          <p:spPr>
            <a:xfrm flipH="1">
              <a:off x="728280" y="1585800"/>
              <a:ext cx="39600" cy="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7" name="Rectangle 173"/>
            <p:cNvSpPr/>
            <p:nvPr/>
          </p:nvSpPr>
          <p:spPr>
            <a:xfrm rot="16200000">
              <a:off x="594720" y="1480320"/>
              <a:ext cx="1407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1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8" name="Line 174"/>
            <p:cNvSpPr/>
            <p:nvPr/>
          </p:nvSpPr>
          <p:spPr>
            <a:xfrm flipH="1">
              <a:off x="728280" y="1241280"/>
              <a:ext cx="39600" cy="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9" name="Rectangle 175"/>
            <p:cNvSpPr/>
            <p:nvPr/>
          </p:nvSpPr>
          <p:spPr>
            <a:xfrm rot="16200000">
              <a:off x="594720" y="1135800"/>
              <a:ext cx="1407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12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0" name="Rectangle 176"/>
            <p:cNvSpPr/>
            <p:nvPr/>
          </p:nvSpPr>
          <p:spPr>
            <a:xfrm rot="16200000">
              <a:off x="-350640" y="2135160"/>
              <a:ext cx="17686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Percent time in MVPA (95% CI)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1" name="Line 177"/>
            <p:cNvSpPr/>
            <p:nvPr/>
          </p:nvSpPr>
          <p:spPr>
            <a:xfrm>
              <a:off x="768240" y="3373200"/>
              <a:ext cx="3597480" cy="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2" name="Line 178"/>
            <p:cNvSpPr/>
            <p:nvPr/>
          </p:nvSpPr>
          <p:spPr>
            <a:xfrm>
              <a:off x="914040" y="3373200"/>
              <a:ext cx="0" cy="3960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7200" bIns="-7200" anchor="t">
              <a:noAutofit/>
            </a:bodyPr>
            <a:p>
              <a:endParaRPr b="0" lang="en-US" sz="2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3" name="Line 180"/>
            <p:cNvSpPr/>
            <p:nvPr/>
          </p:nvSpPr>
          <p:spPr>
            <a:xfrm>
              <a:off x="1434960" y="3373200"/>
              <a:ext cx="0" cy="3960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7200" bIns="-7200" anchor="t">
              <a:noAutofit/>
            </a:bodyPr>
            <a:p>
              <a:endParaRPr b="0" lang="en-US" sz="2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4" name="Line 182"/>
            <p:cNvSpPr/>
            <p:nvPr/>
          </p:nvSpPr>
          <p:spPr>
            <a:xfrm>
              <a:off x="1957320" y="3373200"/>
              <a:ext cx="0" cy="3960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7200" bIns="-7200" anchor="t">
              <a:noAutofit/>
            </a:bodyPr>
            <a:p>
              <a:endParaRPr b="0" lang="en-US" sz="2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5" name="Line 184"/>
            <p:cNvSpPr/>
            <p:nvPr/>
          </p:nvSpPr>
          <p:spPr>
            <a:xfrm>
              <a:off x="2477880" y="3373200"/>
              <a:ext cx="0" cy="3960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7200" bIns="-7200" anchor="t">
              <a:noAutofit/>
            </a:bodyPr>
            <a:p>
              <a:endParaRPr b="0" lang="en-US" sz="2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6" name="Line 186"/>
            <p:cNvSpPr/>
            <p:nvPr/>
          </p:nvSpPr>
          <p:spPr>
            <a:xfrm>
              <a:off x="2998800" y="3373200"/>
              <a:ext cx="0" cy="3960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7200" bIns="-7200" anchor="t">
              <a:noAutofit/>
            </a:bodyPr>
            <a:p>
              <a:endParaRPr b="0" lang="en-US" sz="2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7" name="Line 188"/>
            <p:cNvSpPr/>
            <p:nvPr/>
          </p:nvSpPr>
          <p:spPr>
            <a:xfrm>
              <a:off x="3521160" y="3373200"/>
              <a:ext cx="0" cy="3960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7200" bIns="-7200" anchor="t">
              <a:noAutofit/>
            </a:bodyPr>
            <a:p>
              <a:endParaRPr b="0" lang="en-US" sz="2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8" name="Line 190"/>
            <p:cNvSpPr/>
            <p:nvPr/>
          </p:nvSpPr>
          <p:spPr>
            <a:xfrm>
              <a:off x="4041720" y="3373200"/>
              <a:ext cx="0" cy="3960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7200" bIns="-7200" anchor="t">
              <a:noAutofit/>
            </a:bodyPr>
            <a:p>
              <a:endParaRPr b="0" lang="en-US" sz="2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9" name="Rectangle 200"/>
            <p:cNvSpPr/>
            <p:nvPr/>
          </p:nvSpPr>
          <p:spPr>
            <a:xfrm>
              <a:off x="4831920" y="2336760"/>
              <a:ext cx="177480" cy="988920"/>
            </a:xfrm>
            <a:prstGeom prst="rect">
              <a:avLst/>
            </a:prstGeom>
            <a:solidFill>
              <a:srgbClr val="595959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0" name="Rectangle 201"/>
            <p:cNvSpPr/>
            <p:nvPr/>
          </p:nvSpPr>
          <p:spPr>
            <a:xfrm>
              <a:off x="5360760" y="2117520"/>
              <a:ext cx="172800" cy="1207800"/>
            </a:xfrm>
            <a:prstGeom prst="rect">
              <a:avLst/>
            </a:prstGeom>
            <a:solidFill>
              <a:srgbClr val="595959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1" name="Rectangle 202"/>
            <p:cNvSpPr/>
            <p:nvPr/>
          </p:nvSpPr>
          <p:spPr>
            <a:xfrm>
              <a:off x="5884560" y="1935000"/>
              <a:ext cx="176040" cy="1390320"/>
            </a:xfrm>
            <a:prstGeom prst="rect">
              <a:avLst/>
            </a:prstGeom>
            <a:solidFill>
              <a:srgbClr val="595959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2" name="Rectangle 203"/>
            <p:cNvSpPr/>
            <p:nvPr/>
          </p:nvSpPr>
          <p:spPr>
            <a:xfrm>
              <a:off x="6411600" y="1773360"/>
              <a:ext cx="177480" cy="1552320"/>
            </a:xfrm>
            <a:prstGeom prst="rect">
              <a:avLst/>
            </a:prstGeom>
            <a:solidFill>
              <a:srgbClr val="595959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3" name="Line 204"/>
            <p:cNvSpPr/>
            <p:nvPr/>
          </p:nvSpPr>
          <p:spPr>
            <a:xfrm flipV="1">
              <a:off x="4920840" y="2260080"/>
              <a:ext cx="0" cy="152280"/>
            </a:xfrm>
            <a:prstGeom prst="line">
              <a:avLst/>
            </a:prstGeom>
            <a:ln w="205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4" name="Line 205"/>
            <p:cNvSpPr/>
            <p:nvPr/>
          </p:nvSpPr>
          <p:spPr>
            <a:xfrm flipV="1">
              <a:off x="5447880" y="2057040"/>
              <a:ext cx="0" cy="123480"/>
            </a:xfrm>
            <a:prstGeom prst="line">
              <a:avLst/>
            </a:prstGeom>
            <a:ln w="205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5" name="Line 206"/>
            <p:cNvSpPr/>
            <p:nvPr/>
          </p:nvSpPr>
          <p:spPr>
            <a:xfrm flipV="1">
              <a:off x="5973480" y="1908000"/>
              <a:ext cx="0" cy="56880"/>
            </a:xfrm>
            <a:prstGeom prst="line">
              <a:avLst/>
            </a:prstGeom>
            <a:ln w="205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0080" bIns="10080" anchor="t">
              <a:noAutofit/>
            </a:bodyPr>
            <a:p>
              <a:endParaRPr b="0" lang="en-US" sz="2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6" name="Line 207"/>
            <p:cNvSpPr/>
            <p:nvPr/>
          </p:nvSpPr>
          <p:spPr>
            <a:xfrm flipV="1">
              <a:off x="6500520" y="1690200"/>
              <a:ext cx="0" cy="168120"/>
            </a:xfrm>
            <a:prstGeom prst="line">
              <a:avLst/>
            </a:prstGeom>
            <a:ln w="205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137" name="Rectangle 208"/>
            <p:cNvGrpSpPr/>
            <p:nvPr/>
          </p:nvGrpSpPr>
          <p:grpSpPr>
            <a:xfrm>
              <a:off x="5005080" y="2597040"/>
              <a:ext cx="188640" cy="743400"/>
              <a:chOff x="5005080" y="2597040"/>
              <a:chExt cx="188640" cy="743400"/>
            </a:xfrm>
          </p:grpSpPr>
          <p:pic>
            <p:nvPicPr>
              <p:cNvPr id="138" name="Rectangle 208" descr=""/>
              <p:cNvPicPr/>
              <p:nvPr/>
            </p:nvPicPr>
            <p:blipFill>
              <a:blip r:embed="rId9"/>
              <a:stretch/>
            </p:blipFill>
            <p:spPr>
              <a:xfrm>
                <a:off x="5005080" y="2597040"/>
                <a:ext cx="188640" cy="74340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139" name=""/>
              <p:cNvSpPr/>
              <p:nvPr/>
            </p:nvSpPr>
            <p:spPr>
              <a:xfrm>
                <a:off x="5009760" y="2604960"/>
                <a:ext cx="169560" cy="7203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1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140" name="Rectangle 209"/>
            <p:cNvGrpSpPr/>
            <p:nvPr/>
          </p:nvGrpSpPr>
          <p:grpSpPr>
            <a:xfrm>
              <a:off x="5529240" y="2633400"/>
              <a:ext cx="188640" cy="707040"/>
              <a:chOff x="5529240" y="2633400"/>
              <a:chExt cx="188640" cy="707040"/>
            </a:xfrm>
          </p:grpSpPr>
          <p:pic>
            <p:nvPicPr>
              <p:cNvPr id="141" name="Rectangle 209" descr=""/>
              <p:cNvPicPr/>
              <p:nvPr/>
            </p:nvPicPr>
            <p:blipFill>
              <a:blip r:embed="rId10"/>
              <a:stretch/>
            </p:blipFill>
            <p:spPr>
              <a:xfrm>
                <a:off x="5529240" y="2633400"/>
                <a:ext cx="188640" cy="70704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142" name=""/>
              <p:cNvSpPr/>
              <p:nvPr/>
            </p:nvSpPr>
            <p:spPr>
              <a:xfrm>
                <a:off x="5533560" y="2641320"/>
                <a:ext cx="174600" cy="6843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1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143" name="Rectangle 210"/>
            <p:cNvGrpSpPr/>
            <p:nvPr/>
          </p:nvGrpSpPr>
          <p:grpSpPr>
            <a:xfrm>
              <a:off x="6053400" y="2316600"/>
              <a:ext cx="188640" cy="1023840"/>
              <a:chOff x="6053400" y="2316600"/>
              <a:chExt cx="188640" cy="1023840"/>
            </a:xfrm>
          </p:grpSpPr>
          <p:pic>
            <p:nvPicPr>
              <p:cNvPr id="144" name="Rectangle 210" descr=""/>
              <p:cNvPicPr/>
              <p:nvPr/>
            </p:nvPicPr>
            <p:blipFill>
              <a:blip r:embed="rId11"/>
              <a:stretch/>
            </p:blipFill>
            <p:spPr>
              <a:xfrm>
                <a:off x="6053400" y="2316600"/>
                <a:ext cx="188640" cy="102384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145" name=""/>
              <p:cNvSpPr/>
              <p:nvPr/>
            </p:nvSpPr>
            <p:spPr>
              <a:xfrm>
                <a:off x="6060600" y="2325600"/>
                <a:ext cx="171360" cy="1000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1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146" name="Rectangle 211"/>
            <p:cNvGrpSpPr/>
            <p:nvPr/>
          </p:nvGrpSpPr>
          <p:grpSpPr>
            <a:xfrm>
              <a:off x="6584040" y="2286000"/>
              <a:ext cx="188640" cy="1054440"/>
              <a:chOff x="6584040" y="2286000"/>
              <a:chExt cx="188640" cy="1054440"/>
            </a:xfrm>
          </p:grpSpPr>
          <p:pic>
            <p:nvPicPr>
              <p:cNvPr id="147" name="Rectangle 211" descr=""/>
              <p:cNvPicPr/>
              <p:nvPr/>
            </p:nvPicPr>
            <p:blipFill>
              <a:blip r:embed="rId12"/>
              <a:stretch/>
            </p:blipFill>
            <p:spPr>
              <a:xfrm>
                <a:off x="6584040" y="2286000"/>
                <a:ext cx="188640" cy="105444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148" name=""/>
              <p:cNvSpPr/>
              <p:nvPr/>
            </p:nvSpPr>
            <p:spPr>
              <a:xfrm>
                <a:off x="6589440" y="2293560"/>
                <a:ext cx="169560" cy="10317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1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149" name="Line 212"/>
            <p:cNvSpPr/>
            <p:nvPr/>
          </p:nvSpPr>
          <p:spPr>
            <a:xfrm flipV="1">
              <a:off x="5097240" y="2538000"/>
              <a:ext cx="0" cy="137880"/>
            </a:xfrm>
            <a:prstGeom prst="line">
              <a:avLst/>
            </a:prstGeom>
            <a:ln w="205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0" name="Line 213"/>
            <p:cNvSpPr/>
            <p:nvPr/>
          </p:nvSpPr>
          <p:spPr>
            <a:xfrm flipV="1">
              <a:off x="5622480" y="2596680"/>
              <a:ext cx="0" cy="90360"/>
            </a:xfrm>
            <a:prstGeom prst="line">
              <a:avLst/>
            </a:prstGeom>
            <a:ln w="205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3560" bIns="43560" anchor="t">
              <a:noAutofit/>
            </a:bodyPr>
            <a:p>
              <a:endParaRPr b="0" lang="en-US" sz="2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1" name="Line 214"/>
            <p:cNvSpPr/>
            <p:nvPr/>
          </p:nvSpPr>
          <p:spPr>
            <a:xfrm flipV="1">
              <a:off x="6149520" y="2302920"/>
              <a:ext cx="0" cy="42840"/>
            </a:xfrm>
            <a:prstGeom prst="line">
              <a:avLst/>
            </a:prstGeom>
            <a:ln w="205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960" bIns="-3960" anchor="t">
              <a:noAutofit/>
            </a:bodyPr>
            <a:p>
              <a:endParaRPr b="0" lang="en-US" sz="2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2" name="Line 215"/>
            <p:cNvSpPr/>
            <p:nvPr/>
          </p:nvSpPr>
          <p:spPr>
            <a:xfrm flipV="1">
              <a:off x="6673680" y="2230200"/>
              <a:ext cx="0" cy="125280"/>
            </a:xfrm>
            <a:prstGeom prst="line">
              <a:avLst/>
            </a:prstGeom>
            <a:ln w="205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3" name="Line 216"/>
            <p:cNvSpPr/>
            <p:nvPr/>
          </p:nvSpPr>
          <p:spPr>
            <a:xfrm flipV="1">
              <a:off x="4777920" y="1143000"/>
              <a:ext cx="0" cy="223632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4" name="Line 217"/>
            <p:cNvSpPr/>
            <p:nvPr/>
          </p:nvSpPr>
          <p:spPr>
            <a:xfrm flipH="1">
              <a:off x="4744800" y="3325680"/>
              <a:ext cx="33120" cy="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5" name="Rectangle 218"/>
            <p:cNvSpPr/>
            <p:nvPr/>
          </p:nvSpPr>
          <p:spPr>
            <a:xfrm rot="16200000">
              <a:off x="4644360" y="3242520"/>
              <a:ext cx="572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6" name="Line 219"/>
            <p:cNvSpPr/>
            <p:nvPr/>
          </p:nvSpPr>
          <p:spPr>
            <a:xfrm flipH="1">
              <a:off x="4744800" y="2968560"/>
              <a:ext cx="33120" cy="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7" name="Rectangle 220"/>
            <p:cNvSpPr/>
            <p:nvPr/>
          </p:nvSpPr>
          <p:spPr>
            <a:xfrm rot="16200000">
              <a:off x="4644360" y="2885400"/>
              <a:ext cx="572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2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8" name="Line 221"/>
            <p:cNvSpPr/>
            <p:nvPr/>
          </p:nvSpPr>
          <p:spPr>
            <a:xfrm flipH="1">
              <a:off x="4744800" y="2614680"/>
              <a:ext cx="33120" cy="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9" name="Rectangle 222"/>
            <p:cNvSpPr/>
            <p:nvPr/>
          </p:nvSpPr>
          <p:spPr>
            <a:xfrm rot="16200000">
              <a:off x="4644360" y="2529720"/>
              <a:ext cx="572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4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0" name="Line 223"/>
            <p:cNvSpPr/>
            <p:nvPr/>
          </p:nvSpPr>
          <p:spPr>
            <a:xfrm flipH="1">
              <a:off x="4744800" y="2260440"/>
              <a:ext cx="33120" cy="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1" name="Rectangle 224"/>
            <p:cNvSpPr/>
            <p:nvPr/>
          </p:nvSpPr>
          <p:spPr>
            <a:xfrm rot="16200000">
              <a:off x="4644360" y="2177280"/>
              <a:ext cx="572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6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2" name="Line 225"/>
            <p:cNvSpPr/>
            <p:nvPr/>
          </p:nvSpPr>
          <p:spPr>
            <a:xfrm flipH="1">
              <a:off x="4744800" y="1908000"/>
              <a:ext cx="33120" cy="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3" name="Rectangle 226"/>
            <p:cNvSpPr/>
            <p:nvPr/>
          </p:nvSpPr>
          <p:spPr>
            <a:xfrm rot="16200000">
              <a:off x="4644360" y="1823400"/>
              <a:ext cx="572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8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4" name="Line 227"/>
            <p:cNvSpPr/>
            <p:nvPr/>
          </p:nvSpPr>
          <p:spPr>
            <a:xfrm flipH="1">
              <a:off x="4744800" y="1550880"/>
              <a:ext cx="33120" cy="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5" name="Rectangle 228"/>
            <p:cNvSpPr/>
            <p:nvPr/>
          </p:nvSpPr>
          <p:spPr>
            <a:xfrm rot="16200000">
              <a:off x="4617000" y="1467360"/>
              <a:ext cx="1134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1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6" name="Line 229"/>
            <p:cNvSpPr/>
            <p:nvPr/>
          </p:nvSpPr>
          <p:spPr>
            <a:xfrm flipH="1">
              <a:off x="4744800" y="1197000"/>
              <a:ext cx="33120" cy="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7" name="Rectangle 230"/>
            <p:cNvSpPr/>
            <p:nvPr/>
          </p:nvSpPr>
          <p:spPr>
            <a:xfrm rot="16200000">
              <a:off x="4617000" y="1113480"/>
              <a:ext cx="1134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12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8" name="Line 232"/>
            <p:cNvSpPr/>
            <p:nvPr/>
          </p:nvSpPr>
          <p:spPr>
            <a:xfrm>
              <a:off x="4777920" y="3379680"/>
              <a:ext cx="2039760" cy="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9" name="Line 233"/>
            <p:cNvSpPr/>
            <p:nvPr/>
          </p:nvSpPr>
          <p:spPr>
            <a:xfrm>
              <a:off x="4920840" y="3379680"/>
              <a:ext cx="0" cy="3312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680" bIns="-13680" anchor="t">
              <a:noAutofit/>
            </a:bodyPr>
            <a:p>
              <a:endParaRPr b="0" lang="en-US" sz="2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0" name="Line 235"/>
            <p:cNvSpPr/>
            <p:nvPr/>
          </p:nvSpPr>
          <p:spPr>
            <a:xfrm>
              <a:off x="5447880" y="3379680"/>
              <a:ext cx="0" cy="3312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680" bIns="-13680" anchor="t">
              <a:noAutofit/>
            </a:bodyPr>
            <a:p>
              <a:endParaRPr b="0" lang="en-US" sz="2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1" name="Line 237"/>
            <p:cNvSpPr/>
            <p:nvPr/>
          </p:nvSpPr>
          <p:spPr>
            <a:xfrm>
              <a:off x="5973480" y="3379680"/>
              <a:ext cx="0" cy="3312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680" bIns="-13680" anchor="t">
              <a:noAutofit/>
            </a:bodyPr>
            <a:p>
              <a:endParaRPr b="0" lang="en-US" sz="2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2" name="Line 239"/>
            <p:cNvSpPr/>
            <p:nvPr/>
          </p:nvSpPr>
          <p:spPr>
            <a:xfrm>
              <a:off x="6500520" y="3379680"/>
              <a:ext cx="0" cy="3312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680" bIns="-13680" anchor="t">
              <a:noAutofit/>
            </a:bodyPr>
            <a:p>
              <a:endParaRPr b="0" lang="en-US" sz="21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5889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0-02-03T14:53:07Z</dcterms:created>
  <dc:creator>ENCDAGOO</dc:creator>
  <dc:description/>
  <dc:language>en-US</dc:language>
  <cp:lastModifiedBy>pearc</cp:lastModifiedBy>
  <dcterms:modified xsi:type="dcterms:W3CDTF">2015-08-24T12:03:37Z</dcterms:modified>
  <cp:revision>737</cp:revision>
  <dc:subject/>
  <dc:title>Slide 1</dc:title>
</cp:coreProperties>
</file>